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000000"/>
    <a:srgbClr val="FFEFEF"/>
    <a:srgbClr val="F1F8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2385" autoAdjust="0"/>
  </p:normalViewPr>
  <p:slideViewPr>
    <p:cSldViewPr snapToGrid="0">
      <p:cViewPr varScale="1">
        <p:scale>
          <a:sx n="79" d="100"/>
          <a:sy n="79" d="100"/>
        </p:scale>
        <p:origin x="171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n, Hening" userId="1ad506b0-93f1-4f52-90fb-3dd1b2ccac5e" providerId="ADAL" clId="{05B3A61E-0E23-463F-81BA-68494907A34B}"/>
    <pc:docChg chg="custSel modSld">
      <pc:chgData name="Ren, Hening" userId="1ad506b0-93f1-4f52-90fb-3dd1b2ccac5e" providerId="ADAL" clId="{05B3A61E-0E23-463F-81BA-68494907A34B}" dt="2024-07-10T16:40:15.081" v="9" actId="1076"/>
      <pc:docMkLst>
        <pc:docMk/>
      </pc:docMkLst>
      <pc:sldChg chg="addSp delSp modSp mod">
        <pc:chgData name="Ren, Hening" userId="1ad506b0-93f1-4f52-90fb-3dd1b2ccac5e" providerId="ADAL" clId="{05B3A61E-0E23-463F-81BA-68494907A34B}" dt="2024-07-10T16:40:15.081" v="9" actId="1076"/>
        <pc:sldMkLst>
          <pc:docMk/>
          <pc:sldMk cId="3620991095" sldId="282"/>
        </pc:sldMkLst>
        <pc:spChg chg="del">
          <ac:chgData name="Ren, Hening" userId="1ad506b0-93f1-4f52-90fb-3dd1b2ccac5e" providerId="ADAL" clId="{05B3A61E-0E23-463F-81BA-68494907A34B}" dt="2024-07-10T16:39:58.702" v="6" actId="478"/>
          <ac:spMkLst>
            <pc:docMk/>
            <pc:sldMk cId="3620991095" sldId="282"/>
            <ac:spMk id="3" creationId="{D4CF75A2-CF5C-EC7D-750D-8009C4D3EE3C}"/>
          </ac:spMkLst>
        </pc:spChg>
        <pc:spChg chg="add mod">
          <ac:chgData name="Ren, Hening" userId="1ad506b0-93f1-4f52-90fb-3dd1b2ccac5e" providerId="ADAL" clId="{05B3A61E-0E23-463F-81BA-68494907A34B}" dt="2024-07-10T16:40:15.081" v="9" actId="1076"/>
          <ac:spMkLst>
            <pc:docMk/>
            <pc:sldMk cId="3620991095" sldId="282"/>
            <ac:spMk id="4" creationId="{FF565B13-C1CD-0C32-B768-079C60AADBB7}"/>
          </ac:spMkLst>
        </pc:spChg>
        <pc:spChg chg="mod">
          <ac:chgData name="Ren, Hening" userId="1ad506b0-93f1-4f52-90fb-3dd1b2ccac5e" providerId="ADAL" clId="{05B3A61E-0E23-463F-81BA-68494907A34B}" dt="2024-07-10T16:38:40.704" v="0" actId="1076"/>
          <ac:spMkLst>
            <pc:docMk/>
            <pc:sldMk cId="3620991095" sldId="282"/>
            <ac:spMk id="7" creationId="{EAD3AA5F-2EF9-785E-6D95-7574A3D15251}"/>
          </ac:spMkLst>
        </pc:spChg>
        <pc:spChg chg="mod">
          <ac:chgData name="Ren, Hening" userId="1ad506b0-93f1-4f52-90fb-3dd1b2ccac5e" providerId="ADAL" clId="{05B3A61E-0E23-463F-81BA-68494907A34B}" dt="2024-07-10T16:38:40.704" v="0" actId="1076"/>
          <ac:spMkLst>
            <pc:docMk/>
            <pc:sldMk cId="3620991095" sldId="282"/>
            <ac:spMk id="10" creationId="{D1809460-5F8D-DB82-2248-FC0BF4B2D1D8}"/>
          </ac:spMkLst>
        </pc:spChg>
        <pc:spChg chg="mod">
          <ac:chgData name="Ren, Hening" userId="1ad506b0-93f1-4f52-90fb-3dd1b2ccac5e" providerId="ADAL" clId="{05B3A61E-0E23-463F-81BA-68494907A34B}" dt="2024-07-10T16:38:40.704" v="0" actId="1076"/>
          <ac:spMkLst>
            <pc:docMk/>
            <pc:sldMk cId="3620991095" sldId="282"/>
            <ac:spMk id="12" creationId="{EF02F515-B200-546C-7D36-4B2D9B33B043}"/>
          </ac:spMkLst>
        </pc:spChg>
        <pc:spChg chg="mod">
          <ac:chgData name="Ren, Hening" userId="1ad506b0-93f1-4f52-90fb-3dd1b2ccac5e" providerId="ADAL" clId="{05B3A61E-0E23-463F-81BA-68494907A34B}" dt="2024-07-10T16:38:40.704" v="0" actId="1076"/>
          <ac:spMkLst>
            <pc:docMk/>
            <pc:sldMk cId="3620991095" sldId="282"/>
            <ac:spMk id="13" creationId="{5809BC75-1313-C616-3D26-24B771146338}"/>
          </ac:spMkLst>
        </pc:spChg>
        <pc:spChg chg="mod">
          <ac:chgData name="Ren, Hening" userId="1ad506b0-93f1-4f52-90fb-3dd1b2ccac5e" providerId="ADAL" clId="{05B3A61E-0E23-463F-81BA-68494907A34B}" dt="2024-07-10T16:38:40.704" v="0" actId="1076"/>
          <ac:spMkLst>
            <pc:docMk/>
            <pc:sldMk cId="3620991095" sldId="282"/>
            <ac:spMk id="14" creationId="{A72A4881-FCEC-152B-9B81-2CC002DCEEA2}"/>
          </ac:spMkLst>
        </pc:spChg>
        <pc:graphicFrameChg chg="mod">
          <ac:chgData name="Ren, Hening" userId="1ad506b0-93f1-4f52-90fb-3dd1b2ccac5e" providerId="ADAL" clId="{05B3A61E-0E23-463F-81BA-68494907A34B}" dt="2024-07-10T16:38:40.704" v="0" actId="1076"/>
          <ac:graphicFrameMkLst>
            <pc:docMk/>
            <pc:sldMk cId="3620991095" sldId="282"/>
            <ac:graphicFrameMk id="5" creationId="{972E5C4F-4DBA-4D2B-4D9B-40C3D1E0FB16}"/>
          </ac:graphicFrameMkLst>
        </pc:graphicFrameChg>
        <pc:graphicFrameChg chg="mod">
          <ac:chgData name="Ren, Hening" userId="1ad506b0-93f1-4f52-90fb-3dd1b2ccac5e" providerId="ADAL" clId="{05B3A61E-0E23-463F-81BA-68494907A34B}" dt="2024-07-10T16:38:40.704" v="0" actId="1076"/>
          <ac:graphicFrameMkLst>
            <pc:docMk/>
            <pc:sldMk cId="3620991095" sldId="282"/>
            <ac:graphicFrameMk id="8" creationId="{FBD034F2-3EF7-82F9-B597-0CFC2DA10104}"/>
          </ac:graphicFrameMkLst>
        </pc:graphicFrameChg>
      </pc:sldChg>
    </pc:docChg>
  </pc:docChgLst>
  <pc:docChgLst>
    <pc:chgData name="Ren, Hening" userId="1ad506b0-93f1-4f52-90fb-3dd1b2ccac5e" providerId="ADAL" clId="{4FCC4B04-9924-4DE5-9389-348D8B70642B}"/>
    <pc:docChg chg="undo custSel addSld delSld modSld">
      <pc:chgData name="Ren, Hening" userId="1ad506b0-93f1-4f52-90fb-3dd1b2ccac5e" providerId="ADAL" clId="{4FCC4B04-9924-4DE5-9389-348D8B70642B}" dt="2024-05-30T17:36:39.703" v="13" actId="1076"/>
      <pc:docMkLst>
        <pc:docMk/>
      </pc:docMkLst>
      <pc:sldChg chg="addSp modSp mod">
        <pc:chgData name="Ren, Hening" userId="1ad506b0-93f1-4f52-90fb-3dd1b2ccac5e" providerId="ADAL" clId="{4FCC4B04-9924-4DE5-9389-348D8B70642B}" dt="2024-05-30T17:36:39.703" v="13" actId="1076"/>
        <pc:sldMkLst>
          <pc:docMk/>
          <pc:sldMk cId="3620991095" sldId="282"/>
        </pc:sldMkLst>
        <pc:spChg chg="add mod">
          <ac:chgData name="Ren, Hening" userId="1ad506b0-93f1-4f52-90fb-3dd1b2ccac5e" providerId="ADAL" clId="{4FCC4B04-9924-4DE5-9389-348D8B70642B}" dt="2024-05-30T17:36:39.703" v="13" actId="1076"/>
          <ac:spMkLst>
            <pc:docMk/>
            <pc:sldMk cId="3620991095" sldId="282"/>
            <ac:spMk id="3" creationId="{D4CF75A2-CF5C-EC7D-750D-8009C4D3EE3C}"/>
          </ac:spMkLst>
        </pc:spChg>
      </pc:sldChg>
      <pc:sldChg chg="add del">
        <pc:chgData name="Ren, Hening" userId="1ad506b0-93f1-4f52-90fb-3dd1b2ccac5e" providerId="ADAL" clId="{4FCC4B04-9924-4DE5-9389-348D8B70642B}" dt="2024-05-30T17:36:31.179" v="12" actId="47"/>
        <pc:sldMkLst>
          <pc:docMk/>
          <pc:sldMk cId="981059403" sldId="283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mbcits-my.sharepoint.com/personal/hren_umaryland_edu/Documents/H3K_therapy_2021/Tumor%20Growth%20data/Combined%20AZD_%20AZDH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ren3\Dropbox\H3K-TKI\Copy%20of%20Summary%20219%20Growt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25294842989155"/>
          <c:y val="3.470565180154097E-2"/>
          <c:w val="0.75950679581143254"/>
          <c:h val="0.8404324537054213"/>
        </c:manualLayout>
      </c:layout>
      <c:scatterChart>
        <c:scatterStyle val="smoothMarker"/>
        <c:varyColors val="0"/>
        <c:ser>
          <c:idx val="7"/>
          <c:order val="7"/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219 AZD_ AZDH3'!$A$2:$A$71</c:f>
              <c:numCache>
                <c:formatCode>General</c:formatCode>
                <c:ptCount val="70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  <c:pt idx="31">
                  <c:v>107</c:v>
                </c:pt>
                <c:pt idx="32">
                  <c:v>111</c:v>
                </c:pt>
                <c:pt idx="33">
                  <c:v>114</c:v>
                </c:pt>
                <c:pt idx="34">
                  <c:v>118</c:v>
                </c:pt>
                <c:pt idx="35">
                  <c:v>121</c:v>
                </c:pt>
                <c:pt idx="36">
                  <c:v>125</c:v>
                </c:pt>
                <c:pt idx="38">
                  <c:v>128</c:v>
                </c:pt>
                <c:pt idx="39">
                  <c:v>132</c:v>
                </c:pt>
                <c:pt idx="40">
                  <c:v>135</c:v>
                </c:pt>
                <c:pt idx="41">
                  <c:v>141</c:v>
                </c:pt>
                <c:pt idx="42">
                  <c:v>144</c:v>
                </c:pt>
                <c:pt idx="43">
                  <c:v>148</c:v>
                </c:pt>
                <c:pt idx="44">
                  <c:v>151</c:v>
                </c:pt>
                <c:pt idx="45">
                  <c:v>155</c:v>
                </c:pt>
                <c:pt idx="46">
                  <c:v>158</c:v>
                </c:pt>
                <c:pt idx="47">
                  <c:v>162</c:v>
                </c:pt>
                <c:pt idx="48">
                  <c:v>165</c:v>
                </c:pt>
                <c:pt idx="49">
                  <c:v>169</c:v>
                </c:pt>
                <c:pt idx="50">
                  <c:v>172</c:v>
                </c:pt>
                <c:pt idx="51">
                  <c:v>176</c:v>
                </c:pt>
                <c:pt idx="52">
                  <c:v>179</c:v>
                </c:pt>
                <c:pt idx="53">
                  <c:v>183</c:v>
                </c:pt>
                <c:pt idx="54">
                  <c:v>186</c:v>
                </c:pt>
                <c:pt idx="55">
                  <c:v>190</c:v>
                </c:pt>
                <c:pt idx="56">
                  <c:v>193</c:v>
                </c:pt>
                <c:pt idx="57">
                  <c:v>196</c:v>
                </c:pt>
                <c:pt idx="58">
                  <c:v>199</c:v>
                </c:pt>
                <c:pt idx="59">
                  <c:v>203</c:v>
                </c:pt>
                <c:pt idx="60">
                  <c:v>206</c:v>
                </c:pt>
                <c:pt idx="61">
                  <c:v>210</c:v>
                </c:pt>
                <c:pt idx="62">
                  <c:v>213</c:v>
                </c:pt>
                <c:pt idx="63">
                  <c:v>217</c:v>
                </c:pt>
                <c:pt idx="64">
                  <c:v>220</c:v>
                </c:pt>
                <c:pt idx="65">
                  <c:v>224</c:v>
                </c:pt>
                <c:pt idx="66">
                  <c:v>227</c:v>
                </c:pt>
                <c:pt idx="67">
                  <c:v>231</c:v>
                </c:pt>
                <c:pt idx="68">
                  <c:v>234</c:v>
                </c:pt>
                <c:pt idx="69">
                  <c:v>238</c:v>
                </c:pt>
              </c:numCache>
            </c:numRef>
          </c:xVal>
          <c:yVal>
            <c:numRef>
              <c:f>'219 AZD_ AZDH3'!$I$2:$I$71</c:f>
              <c:numCache>
                <c:formatCode>General</c:formatCode>
                <c:ptCount val="70"/>
                <c:pt idx="0">
                  <c:v>308.45</c:v>
                </c:pt>
                <c:pt idx="1">
                  <c:v>287.33999999999997</c:v>
                </c:pt>
                <c:pt idx="2">
                  <c:v>228.69</c:v>
                </c:pt>
                <c:pt idx="3">
                  <c:v>200.43</c:v>
                </c:pt>
                <c:pt idx="4">
                  <c:v>168.83</c:v>
                </c:pt>
                <c:pt idx="5">
                  <c:v>134.85</c:v>
                </c:pt>
                <c:pt idx="6">
                  <c:v>131.71</c:v>
                </c:pt>
                <c:pt idx="7">
                  <c:v>105</c:v>
                </c:pt>
                <c:pt idx="8">
                  <c:v>85.05</c:v>
                </c:pt>
                <c:pt idx="9">
                  <c:v>90.99</c:v>
                </c:pt>
                <c:pt idx="10">
                  <c:v>99.07</c:v>
                </c:pt>
                <c:pt idx="11">
                  <c:v>110</c:v>
                </c:pt>
                <c:pt idx="12">
                  <c:v>118.98</c:v>
                </c:pt>
                <c:pt idx="13">
                  <c:v>121.01</c:v>
                </c:pt>
                <c:pt idx="14">
                  <c:v>131.22</c:v>
                </c:pt>
                <c:pt idx="15">
                  <c:v>141.12</c:v>
                </c:pt>
                <c:pt idx="16">
                  <c:v>161.87</c:v>
                </c:pt>
                <c:pt idx="17">
                  <c:v>171</c:v>
                </c:pt>
                <c:pt idx="18">
                  <c:v>188.36</c:v>
                </c:pt>
                <c:pt idx="19">
                  <c:v>204.8</c:v>
                </c:pt>
                <c:pt idx="20">
                  <c:v>221.81</c:v>
                </c:pt>
                <c:pt idx="21">
                  <c:v>244.65</c:v>
                </c:pt>
                <c:pt idx="22">
                  <c:v>258.94</c:v>
                </c:pt>
                <c:pt idx="23">
                  <c:v>279.3</c:v>
                </c:pt>
                <c:pt idx="24">
                  <c:v>355.74</c:v>
                </c:pt>
                <c:pt idx="25">
                  <c:v>403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A24-4D66-A2FF-BADC1EAEE179}"/>
            </c:ext>
          </c:extLst>
        </c:ser>
        <c:ser>
          <c:idx val="8"/>
          <c:order val="8"/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0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'219 AZD_ AZDH3'!$A$2:$A$71</c:f>
              <c:numCache>
                <c:formatCode>General</c:formatCode>
                <c:ptCount val="70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  <c:pt idx="31">
                  <c:v>107</c:v>
                </c:pt>
                <c:pt idx="32">
                  <c:v>111</c:v>
                </c:pt>
                <c:pt idx="33">
                  <c:v>114</c:v>
                </c:pt>
                <c:pt idx="34">
                  <c:v>118</c:v>
                </c:pt>
                <c:pt idx="35">
                  <c:v>121</c:v>
                </c:pt>
                <c:pt idx="36">
                  <c:v>125</c:v>
                </c:pt>
                <c:pt idx="38">
                  <c:v>128</c:v>
                </c:pt>
                <c:pt idx="39">
                  <c:v>132</c:v>
                </c:pt>
                <c:pt idx="40">
                  <c:v>135</c:v>
                </c:pt>
                <c:pt idx="41">
                  <c:v>141</c:v>
                </c:pt>
                <c:pt idx="42">
                  <c:v>144</c:v>
                </c:pt>
                <c:pt idx="43">
                  <c:v>148</c:v>
                </c:pt>
                <c:pt idx="44">
                  <c:v>151</c:v>
                </c:pt>
                <c:pt idx="45">
                  <c:v>155</c:v>
                </c:pt>
                <c:pt idx="46">
                  <c:v>158</c:v>
                </c:pt>
                <c:pt idx="47">
                  <c:v>162</c:v>
                </c:pt>
                <c:pt idx="48">
                  <c:v>165</c:v>
                </c:pt>
                <c:pt idx="49">
                  <c:v>169</c:v>
                </c:pt>
                <c:pt idx="50">
                  <c:v>172</c:v>
                </c:pt>
                <c:pt idx="51">
                  <c:v>176</c:v>
                </c:pt>
                <c:pt idx="52">
                  <c:v>179</c:v>
                </c:pt>
                <c:pt idx="53">
                  <c:v>183</c:v>
                </c:pt>
                <c:pt idx="54">
                  <c:v>186</c:v>
                </c:pt>
                <c:pt idx="55">
                  <c:v>190</c:v>
                </c:pt>
                <c:pt idx="56">
                  <c:v>193</c:v>
                </c:pt>
                <c:pt idx="57">
                  <c:v>196</c:v>
                </c:pt>
                <c:pt idx="58">
                  <c:v>199</c:v>
                </c:pt>
                <c:pt idx="59">
                  <c:v>203</c:v>
                </c:pt>
                <c:pt idx="60">
                  <c:v>206</c:v>
                </c:pt>
                <c:pt idx="61">
                  <c:v>210</c:v>
                </c:pt>
                <c:pt idx="62">
                  <c:v>213</c:v>
                </c:pt>
                <c:pt idx="63">
                  <c:v>217</c:v>
                </c:pt>
                <c:pt idx="64">
                  <c:v>220</c:v>
                </c:pt>
                <c:pt idx="65">
                  <c:v>224</c:v>
                </c:pt>
                <c:pt idx="66">
                  <c:v>227</c:v>
                </c:pt>
                <c:pt idx="67">
                  <c:v>231</c:v>
                </c:pt>
                <c:pt idx="68">
                  <c:v>234</c:v>
                </c:pt>
                <c:pt idx="69">
                  <c:v>238</c:v>
                </c:pt>
              </c:numCache>
            </c:numRef>
          </c:xVal>
          <c:yVal>
            <c:numRef>
              <c:f>'219 AZD_ AZDH3'!$J$2:$J$71</c:f>
              <c:numCache>
                <c:formatCode>General</c:formatCode>
                <c:ptCount val="70"/>
                <c:pt idx="0">
                  <c:v>245.19</c:v>
                </c:pt>
                <c:pt idx="1">
                  <c:v>221.95</c:v>
                </c:pt>
                <c:pt idx="2">
                  <c:v>178.75</c:v>
                </c:pt>
                <c:pt idx="3">
                  <c:v>156.6</c:v>
                </c:pt>
                <c:pt idx="4">
                  <c:v>127.01</c:v>
                </c:pt>
                <c:pt idx="5">
                  <c:v>95.51</c:v>
                </c:pt>
                <c:pt idx="6">
                  <c:v>85.18</c:v>
                </c:pt>
                <c:pt idx="7">
                  <c:v>75.63</c:v>
                </c:pt>
                <c:pt idx="8">
                  <c:v>80.430000000000007</c:v>
                </c:pt>
                <c:pt idx="9">
                  <c:v>82.83</c:v>
                </c:pt>
                <c:pt idx="10">
                  <c:v>91.04</c:v>
                </c:pt>
                <c:pt idx="11">
                  <c:v>97.34</c:v>
                </c:pt>
                <c:pt idx="12">
                  <c:v>106.74</c:v>
                </c:pt>
                <c:pt idx="13">
                  <c:v>109.55</c:v>
                </c:pt>
                <c:pt idx="14">
                  <c:v>110.96</c:v>
                </c:pt>
                <c:pt idx="15">
                  <c:v>115.17</c:v>
                </c:pt>
                <c:pt idx="16">
                  <c:v>123.93</c:v>
                </c:pt>
                <c:pt idx="17">
                  <c:v>133.1</c:v>
                </c:pt>
                <c:pt idx="18">
                  <c:v>146.19999999999999</c:v>
                </c:pt>
                <c:pt idx="19">
                  <c:v>125.54</c:v>
                </c:pt>
                <c:pt idx="20">
                  <c:v>136.46</c:v>
                </c:pt>
                <c:pt idx="21">
                  <c:v>146.33000000000001</c:v>
                </c:pt>
                <c:pt idx="22">
                  <c:v>162</c:v>
                </c:pt>
                <c:pt idx="23">
                  <c:v>199.76</c:v>
                </c:pt>
                <c:pt idx="24">
                  <c:v>219.01</c:v>
                </c:pt>
                <c:pt idx="25">
                  <c:v>241.06</c:v>
                </c:pt>
                <c:pt idx="26">
                  <c:v>282.44</c:v>
                </c:pt>
                <c:pt idx="27">
                  <c:v>306.56</c:v>
                </c:pt>
                <c:pt idx="28">
                  <c:v>337.66</c:v>
                </c:pt>
                <c:pt idx="29">
                  <c:v>358.4</c:v>
                </c:pt>
                <c:pt idx="30">
                  <c:v>402.1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A24-4D66-A2FF-BADC1EAEE179}"/>
            </c:ext>
          </c:extLst>
        </c:ser>
        <c:ser>
          <c:idx val="9"/>
          <c:order val="9"/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0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'219 AZD_ AZDH3'!$A$2:$A$71</c:f>
              <c:numCache>
                <c:formatCode>General</c:formatCode>
                <c:ptCount val="70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  <c:pt idx="31">
                  <c:v>107</c:v>
                </c:pt>
                <c:pt idx="32">
                  <c:v>111</c:v>
                </c:pt>
                <c:pt idx="33">
                  <c:v>114</c:v>
                </c:pt>
                <c:pt idx="34">
                  <c:v>118</c:v>
                </c:pt>
                <c:pt idx="35">
                  <c:v>121</c:v>
                </c:pt>
                <c:pt idx="36">
                  <c:v>125</c:v>
                </c:pt>
                <c:pt idx="38">
                  <c:v>128</c:v>
                </c:pt>
                <c:pt idx="39">
                  <c:v>132</c:v>
                </c:pt>
                <c:pt idx="40">
                  <c:v>135</c:v>
                </c:pt>
                <c:pt idx="41">
                  <c:v>141</c:v>
                </c:pt>
                <c:pt idx="42">
                  <c:v>144</c:v>
                </c:pt>
                <c:pt idx="43">
                  <c:v>148</c:v>
                </c:pt>
                <c:pt idx="44">
                  <c:v>151</c:v>
                </c:pt>
                <c:pt idx="45">
                  <c:v>155</c:v>
                </c:pt>
                <c:pt idx="46">
                  <c:v>158</c:v>
                </c:pt>
                <c:pt idx="47">
                  <c:v>162</c:v>
                </c:pt>
                <c:pt idx="48">
                  <c:v>165</c:v>
                </c:pt>
                <c:pt idx="49">
                  <c:v>169</c:v>
                </c:pt>
                <c:pt idx="50">
                  <c:v>172</c:v>
                </c:pt>
                <c:pt idx="51">
                  <c:v>176</c:v>
                </c:pt>
                <c:pt idx="52">
                  <c:v>179</c:v>
                </c:pt>
                <c:pt idx="53">
                  <c:v>183</c:v>
                </c:pt>
                <c:pt idx="54">
                  <c:v>186</c:v>
                </c:pt>
                <c:pt idx="55">
                  <c:v>190</c:v>
                </c:pt>
                <c:pt idx="56">
                  <c:v>193</c:v>
                </c:pt>
                <c:pt idx="57">
                  <c:v>196</c:v>
                </c:pt>
                <c:pt idx="58">
                  <c:v>199</c:v>
                </c:pt>
                <c:pt idx="59">
                  <c:v>203</c:v>
                </c:pt>
                <c:pt idx="60">
                  <c:v>206</c:v>
                </c:pt>
                <c:pt idx="61">
                  <c:v>210</c:v>
                </c:pt>
                <c:pt idx="62">
                  <c:v>213</c:v>
                </c:pt>
                <c:pt idx="63">
                  <c:v>217</c:v>
                </c:pt>
                <c:pt idx="64">
                  <c:v>220</c:v>
                </c:pt>
                <c:pt idx="65">
                  <c:v>224</c:v>
                </c:pt>
                <c:pt idx="66">
                  <c:v>227</c:v>
                </c:pt>
                <c:pt idx="67">
                  <c:v>231</c:v>
                </c:pt>
                <c:pt idx="68">
                  <c:v>234</c:v>
                </c:pt>
                <c:pt idx="69">
                  <c:v>238</c:v>
                </c:pt>
              </c:numCache>
            </c:numRef>
          </c:xVal>
          <c:yVal>
            <c:numRef>
              <c:f>'219 AZD_ AZDH3'!$K$2:$K$71</c:f>
              <c:numCache>
                <c:formatCode>General</c:formatCode>
                <c:ptCount val="70"/>
                <c:pt idx="0">
                  <c:v>240.94</c:v>
                </c:pt>
                <c:pt idx="1">
                  <c:v>225.26</c:v>
                </c:pt>
                <c:pt idx="2">
                  <c:v>176.42</c:v>
                </c:pt>
                <c:pt idx="3">
                  <c:v>132.28</c:v>
                </c:pt>
                <c:pt idx="4">
                  <c:v>101.12</c:v>
                </c:pt>
                <c:pt idx="5">
                  <c:v>95.65</c:v>
                </c:pt>
                <c:pt idx="6">
                  <c:v>100.35</c:v>
                </c:pt>
                <c:pt idx="7">
                  <c:v>88.48</c:v>
                </c:pt>
                <c:pt idx="8">
                  <c:v>94.77</c:v>
                </c:pt>
                <c:pt idx="9">
                  <c:v>99.14</c:v>
                </c:pt>
                <c:pt idx="10">
                  <c:v>108.19</c:v>
                </c:pt>
                <c:pt idx="11">
                  <c:v>112.8</c:v>
                </c:pt>
                <c:pt idx="12">
                  <c:v>127.83</c:v>
                </c:pt>
                <c:pt idx="13">
                  <c:v>135.76</c:v>
                </c:pt>
                <c:pt idx="14">
                  <c:v>146.97999999999999</c:v>
                </c:pt>
                <c:pt idx="15">
                  <c:v>153.76</c:v>
                </c:pt>
                <c:pt idx="16">
                  <c:v>160.74</c:v>
                </c:pt>
                <c:pt idx="17">
                  <c:v>167.94</c:v>
                </c:pt>
                <c:pt idx="18">
                  <c:v>177.45</c:v>
                </c:pt>
                <c:pt idx="19">
                  <c:v>185.13</c:v>
                </c:pt>
                <c:pt idx="20">
                  <c:v>211.86</c:v>
                </c:pt>
                <c:pt idx="21">
                  <c:v>233.28</c:v>
                </c:pt>
                <c:pt idx="22">
                  <c:v>261.56</c:v>
                </c:pt>
                <c:pt idx="23">
                  <c:v>288.99</c:v>
                </c:pt>
                <c:pt idx="24">
                  <c:v>337.56</c:v>
                </c:pt>
                <c:pt idx="25">
                  <c:v>375.7</c:v>
                </c:pt>
                <c:pt idx="26">
                  <c:v>439.6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A24-4D66-A2FF-BADC1EAEE179}"/>
            </c:ext>
          </c:extLst>
        </c:ser>
        <c:ser>
          <c:idx val="10"/>
          <c:order val="10"/>
          <c:spPr>
            <a:ln w="19050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'219 AZD_ AZDH3'!$A$2:$A$71</c:f>
              <c:numCache>
                <c:formatCode>General</c:formatCode>
                <c:ptCount val="70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  <c:pt idx="31">
                  <c:v>107</c:v>
                </c:pt>
                <c:pt idx="32">
                  <c:v>111</c:v>
                </c:pt>
                <c:pt idx="33">
                  <c:v>114</c:v>
                </c:pt>
                <c:pt idx="34">
                  <c:v>118</c:v>
                </c:pt>
                <c:pt idx="35">
                  <c:v>121</c:v>
                </c:pt>
                <c:pt idx="36">
                  <c:v>125</c:v>
                </c:pt>
                <c:pt idx="38">
                  <c:v>128</c:v>
                </c:pt>
                <c:pt idx="39">
                  <c:v>132</c:v>
                </c:pt>
                <c:pt idx="40">
                  <c:v>135</c:v>
                </c:pt>
                <c:pt idx="41">
                  <c:v>141</c:v>
                </c:pt>
                <c:pt idx="42">
                  <c:v>144</c:v>
                </c:pt>
                <c:pt idx="43">
                  <c:v>148</c:v>
                </c:pt>
                <c:pt idx="44">
                  <c:v>151</c:v>
                </c:pt>
                <c:pt idx="45">
                  <c:v>155</c:v>
                </c:pt>
                <c:pt idx="46">
                  <c:v>158</c:v>
                </c:pt>
                <c:pt idx="47">
                  <c:v>162</c:v>
                </c:pt>
                <c:pt idx="48">
                  <c:v>165</c:v>
                </c:pt>
                <c:pt idx="49">
                  <c:v>169</c:v>
                </c:pt>
                <c:pt idx="50">
                  <c:v>172</c:v>
                </c:pt>
                <c:pt idx="51">
                  <c:v>176</c:v>
                </c:pt>
                <c:pt idx="52">
                  <c:v>179</c:v>
                </c:pt>
                <c:pt idx="53">
                  <c:v>183</c:v>
                </c:pt>
                <c:pt idx="54">
                  <c:v>186</c:v>
                </c:pt>
                <c:pt idx="55">
                  <c:v>190</c:v>
                </c:pt>
                <c:pt idx="56">
                  <c:v>193</c:v>
                </c:pt>
                <c:pt idx="57">
                  <c:v>196</c:v>
                </c:pt>
                <c:pt idx="58">
                  <c:v>199</c:v>
                </c:pt>
                <c:pt idx="59">
                  <c:v>203</c:v>
                </c:pt>
                <c:pt idx="60">
                  <c:v>206</c:v>
                </c:pt>
                <c:pt idx="61">
                  <c:v>210</c:v>
                </c:pt>
                <c:pt idx="62">
                  <c:v>213</c:v>
                </c:pt>
                <c:pt idx="63">
                  <c:v>217</c:v>
                </c:pt>
                <c:pt idx="64">
                  <c:v>220</c:v>
                </c:pt>
                <c:pt idx="65">
                  <c:v>224</c:v>
                </c:pt>
                <c:pt idx="66">
                  <c:v>227</c:v>
                </c:pt>
                <c:pt idx="67">
                  <c:v>231</c:v>
                </c:pt>
                <c:pt idx="68">
                  <c:v>234</c:v>
                </c:pt>
                <c:pt idx="69">
                  <c:v>238</c:v>
                </c:pt>
              </c:numCache>
            </c:numRef>
          </c:xVal>
          <c:yVal>
            <c:numRef>
              <c:f>'219 AZD_ AZDH3'!$L$2:$L$71</c:f>
              <c:numCache>
                <c:formatCode>General</c:formatCode>
                <c:ptCount val="70"/>
                <c:pt idx="0">
                  <c:v>329.6</c:v>
                </c:pt>
                <c:pt idx="1">
                  <c:v>307.2</c:v>
                </c:pt>
                <c:pt idx="2">
                  <c:v>265.58999999999997</c:v>
                </c:pt>
                <c:pt idx="3">
                  <c:v>254.02</c:v>
                </c:pt>
                <c:pt idx="4">
                  <c:v>213.15</c:v>
                </c:pt>
                <c:pt idx="5">
                  <c:v>167.94</c:v>
                </c:pt>
                <c:pt idx="6">
                  <c:v>155.65</c:v>
                </c:pt>
                <c:pt idx="7">
                  <c:v>149.91999999999999</c:v>
                </c:pt>
                <c:pt idx="8">
                  <c:v>145.12</c:v>
                </c:pt>
                <c:pt idx="9">
                  <c:v>137.91999999999999</c:v>
                </c:pt>
                <c:pt idx="10">
                  <c:v>163.84</c:v>
                </c:pt>
                <c:pt idx="11">
                  <c:v>170.58</c:v>
                </c:pt>
                <c:pt idx="12">
                  <c:v>176.42</c:v>
                </c:pt>
                <c:pt idx="13">
                  <c:v>202.34</c:v>
                </c:pt>
                <c:pt idx="14">
                  <c:v>215.6</c:v>
                </c:pt>
                <c:pt idx="15">
                  <c:v>226.85</c:v>
                </c:pt>
                <c:pt idx="16">
                  <c:v>243.65</c:v>
                </c:pt>
                <c:pt idx="17">
                  <c:v>247.8</c:v>
                </c:pt>
                <c:pt idx="18">
                  <c:v>271.47000000000003</c:v>
                </c:pt>
                <c:pt idx="19">
                  <c:v>284.58999999999997</c:v>
                </c:pt>
                <c:pt idx="20">
                  <c:v>304.2</c:v>
                </c:pt>
                <c:pt idx="21">
                  <c:v>329.6</c:v>
                </c:pt>
                <c:pt idx="22">
                  <c:v>370.44</c:v>
                </c:pt>
                <c:pt idx="23">
                  <c:v>419.8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A24-4D66-A2FF-BADC1EAEE179}"/>
            </c:ext>
          </c:extLst>
        </c:ser>
        <c:ser>
          <c:idx val="11"/>
          <c:order val="11"/>
          <c:spPr>
            <a:ln w="19050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xVal>
            <c:numRef>
              <c:f>'219 AZD_ AZDH3'!$A$2:$A$71</c:f>
              <c:numCache>
                <c:formatCode>General</c:formatCode>
                <c:ptCount val="70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  <c:pt idx="31">
                  <c:v>107</c:v>
                </c:pt>
                <c:pt idx="32">
                  <c:v>111</c:v>
                </c:pt>
                <c:pt idx="33">
                  <c:v>114</c:v>
                </c:pt>
                <c:pt idx="34">
                  <c:v>118</c:v>
                </c:pt>
                <c:pt idx="35">
                  <c:v>121</c:v>
                </c:pt>
                <c:pt idx="36">
                  <c:v>125</c:v>
                </c:pt>
                <c:pt idx="38">
                  <c:v>128</c:v>
                </c:pt>
                <c:pt idx="39">
                  <c:v>132</c:v>
                </c:pt>
                <c:pt idx="40">
                  <c:v>135</c:v>
                </c:pt>
                <c:pt idx="41">
                  <c:v>141</c:v>
                </c:pt>
                <c:pt idx="42">
                  <c:v>144</c:v>
                </c:pt>
                <c:pt idx="43">
                  <c:v>148</c:v>
                </c:pt>
                <c:pt idx="44">
                  <c:v>151</c:v>
                </c:pt>
                <c:pt idx="45">
                  <c:v>155</c:v>
                </c:pt>
                <c:pt idx="46">
                  <c:v>158</c:v>
                </c:pt>
                <c:pt idx="47">
                  <c:v>162</c:v>
                </c:pt>
                <c:pt idx="48">
                  <c:v>165</c:v>
                </c:pt>
                <c:pt idx="49">
                  <c:v>169</c:v>
                </c:pt>
                <c:pt idx="50">
                  <c:v>172</c:v>
                </c:pt>
                <c:pt idx="51">
                  <c:v>176</c:v>
                </c:pt>
                <c:pt idx="52">
                  <c:v>179</c:v>
                </c:pt>
                <c:pt idx="53">
                  <c:v>183</c:v>
                </c:pt>
                <c:pt idx="54">
                  <c:v>186</c:v>
                </c:pt>
                <c:pt idx="55">
                  <c:v>190</c:v>
                </c:pt>
                <c:pt idx="56">
                  <c:v>193</c:v>
                </c:pt>
                <c:pt idx="57">
                  <c:v>196</c:v>
                </c:pt>
                <c:pt idx="58">
                  <c:v>199</c:v>
                </c:pt>
                <c:pt idx="59">
                  <c:v>203</c:v>
                </c:pt>
                <c:pt idx="60">
                  <c:v>206</c:v>
                </c:pt>
                <c:pt idx="61">
                  <c:v>210</c:v>
                </c:pt>
                <c:pt idx="62">
                  <c:v>213</c:v>
                </c:pt>
                <c:pt idx="63">
                  <c:v>217</c:v>
                </c:pt>
                <c:pt idx="64">
                  <c:v>220</c:v>
                </c:pt>
                <c:pt idx="65">
                  <c:v>224</c:v>
                </c:pt>
                <c:pt idx="66">
                  <c:v>227</c:v>
                </c:pt>
                <c:pt idx="67">
                  <c:v>231</c:v>
                </c:pt>
                <c:pt idx="68">
                  <c:v>234</c:v>
                </c:pt>
                <c:pt idx="69">
                  <c:v>238</c:v>
                </c:pt>
              </c:numCache>
            </c:numRef>
          </c:xVal>
          <c:yVal>
            <c:numRef>
              <c:f>'219 AZD_ AZDH3'!$M$2:$M$71</c:f>
              <c:numCache>
                <c:formatCode>General</c:formatCode>
                <c:ptCount val="70"/>
                <c:pt idx="0">
                  <c:v>213.56</c:v>
                </c:pt>
                <c:pt idx="1">
                  <c:v>183.75</c:v>
                </c:pt>
                <c:pt idx="2">
                  <c:v>168.78</c:v>
                </c:pt>
                <c:pt idx="3">
                  <c:v>134.94999999999999</c:v>
                </c:pt>
                <c:pt idx="4">
                  <c:v>120.93</c:v>
                </c:pt>
                <c:pt idx="5">
                  <c:v>104.43</c:v>
                </c:pt>
                <c:pt idx="6">
                  <c:v>94.77</c:v>
                </c:pt>
                <c:pt idx="7">
                  <c:v>88.48</c:v>
                </c:pt>
                <c:pt idx="8">
                  <c:v>91.85</c:v>
                </c:pt>
                <c:pt idx="9">
                  <c:v>98.31</c:v>
                </c:pt>
                <c:pt idx="10">
                  <c:v>105.59</c:v>
                </c:pt>
                <c:pt idx="11">
                  <c:v>112.09</c:v>
                </c:pt>
                <c:pt idx="12">
                  <c:v>115.34</c:v>
                </c:pt>
                <c:pt idx="13">
                  <c:v>127.8</c:v>
                </c:pt>
                <c:pt idx="14">
                  <c:v>149.91999999999999</c:v>
                </c:pt>
                <c:pt idx="15">
                  <c:v>165.89</c:v>
                </c:pt>
                <c:pt idx="16">
                  <c:v>181.3</c:v>
                </c:pt>
                <c:pt idx="17">
                  <c:v>196.99</c:v>
                </c:pt>
                <c:pt idx="18">
                  <c:v>223.82</c:v>
                </c:pt>
                <c:pt idx="19">
                  <c:v>250.31</c:v>
                </c:pt>
                <c:pt idx="20">
                  <c:v>288</c:v>
                </c:pt>
                <c:pt idx="21">
                  <c:v>312.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BA24-4D66-A2FF-BADC1EAEE179}"/>
            </c:ext>
          </c:extLst>
        </c:ser>
        <c:ser>
          <c:idx val="12"/>
          <c:order val="12"/>
          <c:spPr>
            <a:ln w="19050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solidFill>
                  <a:schemeClr val="accent1">
                    <a:lumMod val="80000"/>
                    <a:lumOff val="20000"/>
                  </a:schemeClr>
                </a:solidFill>
              </a:ln>
              <a:effectLst/>
            </c:spPr>
          </c:marker>
          <c:xVal>
            <c:numRef>
              <c:f>'219 AZD_ AZDH3'!$A$2:$A$71</c:f>
              <c:numCache>
                <c:formatCode>General</c:formatCode>
                <c:ptCount val="70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  <c:pt idx="31">
                  <c:v>107</c:v>
                </c:pt>
                <c:pt idx="32">
                  <c:v>111</c:v>
                </c:pt>
                <c:pt idx="33">
                  <c:v>114</c:v>
                </c:pt>
                <c:pt idx="34">
                  <c:v>118</c:v>
                </c:pt>
                <c:pt idx="35">
                  <c:v>121</c:v>
                </c:pt>
                <c:pt idx="36">
                  <c:v>125</c:v>
                </c:pt>
                <c:pt idx="38">
                  <c:v>128</c:v>
                </c:pt>
                <c:pt idx="39">
                  <c:v>132</c:v>
                </c:pt>
                <c:pt idx="40">
                  <c:v>135</c:v>
                </c:pt>
                <c:pt idx="41">
                  <c:v>141</c:v>
                </c:pt>
                <c:pt idx="42">
                  <c:v>144</c:v>
                </c:pt>
                <c:pt idx="43">
                  <c:v>148</c:v>
                </c:pt>
                <c:pt idx="44">
                  <c:v>151</c:v>
                </c:pt>
                <c:pt idx="45">
                  <c:v>155</c:v>
                </c:pt>
                <c:pt idx="46">
                  <c:v>158</c:v>
                </c:pt>
                <c:pt idx="47">
                  <c:v>162</c:v>
                </c:pt>
                <c:pt idx="48">
                  <c:v>165</c:v>
                </c:pt>
                <c:pt idx="49">
                  <c:v>169</c:v>
                </c:pt>
                <c:pt idx="50">
                  <c:v>172</c:v>
                </c:pt>
                <c:pt idx="51">
                  <c:v>176</c:v>
                </c:pt>
                <c:pt idx="52">
                  <c:v>179</c:v>
                </c:pt>
                <c:pt idx="53">
                  <c:v>183</c:v>
                </c:pt>
                <c:pt idx="54">
                  <c:v>186</c:v>
                </c:pt>
                <c:pt idx="55">
                  <c:v>190</c:v>
                </c:pt>
                <c:pt idx="56">
                  <c:v>193</c:v>
                </c:pt>
                <c:pt idx="57">
                  <c:v>196</c:v>
                </c:pt>
                <c:pt idx="58">
                  <c:v>199</c:v>
                </c:pt>
                <c:pt idx="59">
                  <c:v>203</c:v>
                </c:pt>
                <c:pt idx="60">
                  <c:v>206</c:v>
                </c:pt>
                <c:pt idx="61">
                  <c:v>210</c:v>
                </c:pt>
                <c:pt idx="62">
                  <c:v>213</c:v>
                </c:pt>
                <c:pt idx="63">
                  <c:v>217</c:v>
                </c:pt>
                <c:pt idx="64">
                  <c:v>220</c:v>
                </c:pt>
                <c:pt idx="65">
                  <c:v>224</c:v>
                </c:pt>
                <c:pt idx="66">
                  <c:v>227</c:v>
                </c:pt>
                <c:pt idx="67">
                  <c:v>231</c:v>
                </c:pt>
                <c:pt idx="68">
                  <c:v>234</c:v>
                </c:pt>
                <c:pt idx="69">
                  <c:v>238</c:v>
                </c:pt>
              </c:numCache>
            </c:numRef>
          </c:xVal>
          <c:yVal>
            <c:numRef>
              <c:f>'219 AZD_ AZDH3'!$N$2:$N$71</c:f>
              <c:numCache>
                <c:formatCode>General</c:formatCode>
                <c:ptCount val="70"/>
                <c:pt idx="0">
                  <c:v>310.27999999999997</c:v>
                </c:pt>
                <c:pt idx="1">
                  <c:v>266.45</c:v>
                </c:pt>
                <c:pt idx="2">
                  <c:v>241.97</c:v>
                </c:pt>
                <c:pt idx="3">
                  <c:v>178.96</c:v>
                </c:pt>
                <c:pt idx="4">
                  <c:v>161.84</c:v>
                </c:pt>
                <c:pt idx="5">
                  <c:v>145.41</c:v>
                </c:pt>
                <c:pt idx="6">
                  <c:v>154.21</c:v>
                </c:pt>
                <c:pt idx="7">
                  <c:v>144.15</c:v>
                </c:pt>
                <c:pt idx="8">
                  <c:v>146.07</c:v>
                </c:pt>
                <c:pt idx="9">
                  <c:v>159.74</c:v>
                </c:pt>
                <c:pt idx="10">
                  <c:v>161.16999999999999</c:v>
                </c:pt>
                <c:pt idx="11">
                  <c:v>174.24</c:v>
                </c:pt>
                <c:pt idx="12">
                  <c:v>187.27</c:v>
                </c:pt>
                <c:pt idx="13">
                  <c:v>198.45</c:v>
                </c:pt>
                <c:pt idx="14">
                  <c:v>229.99</c:v>
                </c:pt>
                <c:pt idx="15">
                  <c:v>241.88</c:v>
                </c:pt>
                <c:pt idx="16">
                  <c:v>256.94</c:v>
                </c:pt>
                <c:pt idx="17">
                  <c:v>260.11</c:v>
                </c:pt>
                <c:pt idx="18">
                  <c:v>281.63</c:v>
                </c:pt>
                <c:pt idx="19">
                  <c:v>299.57</c:v>
                </c:pt>
                <c:pt idx="20">
                  <c:v>337.89</c:v>
                </c:pt>
                <c:pt idx="21">
                  <c:v>359.8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BA24-4D66-A2FF-BADC1EAEE1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04913376"/>
        <c:axId val="1704901312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spPr>
                  <a:ln w="19050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219 AZD_ AZDH3'!$A$2:$A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  <c:pt idx="31">
                        <c:v>107</c:v>
                      </c:pt>
                      <c:pt idx="32">
                        <c:v>111</c:v>
                      </c:pt>
                      <c:pt idx="33">
                        <c:v>114</c:v>
                      </c:pt>
                      <c:pt idx="34">
                        <c:v>118</c:v>
                      </c:pt>
                      <c:pt idx="35">
                        <c:v>121</c:v>
                      </c:pt>
                      <c:pt idx="36">
                        <c:v>125</c:v>
                      </c:pt>
                      <c:pt idx="38">
                        <c:v>128</c:v>
                      </c:pt>
                      <c:pt idx="39">
                        <c:v>132</c:v>
                      </c:pt>
                      <c:pt idx="40">
                        <c:v>135</c:v>
                      </c:pt>
                      <c:pt idx="41">
                        <c:v>141</c:v>
                      </c:pt>
                      <c:pt idx="42">
                        <c:v>144</c:v>
                      </c:pt>
                      <c:pt idx="43">
                        <c:v>148</c:v>
                      </c:pt>
                      <c:pt idx="44">
                        <c:v>151</c:v>
                      </c:pt>
                      <c:pt idx="45">
                        <c:v>155</c:v>
                      </c:pt>
                      <c:pt idx="46">
                        <c:v>158</c:v>
                      </c:pt>
                      <c:pt idx="47">
                        <c:v>162</c:v>
                      </c:pt>
                      <c:pt idx="48">
                        <c:v>165</c:v>
                      </c:pt>
                      <c:pt idx="49">
                        <c:v>169</c:v>
                      </c:pt>
                      <c:pt idx="50">
                        <c:v>172</c:v>
                      </c:pt>
                      <c:pt idx="51">
                        <c:v>176</c:v>
                      </c:pt>
                      <c:pt idx="52">
                        <c:v>179</c:v>
                      </c:pt>
                      <c:pt idx="53">
                        <c:v>183</c:v>
                      </c:pt>
                      <c:pt idx="54">
                        <c:v>186</c:v>
                      </c:pt>
                      <c:pt idx="55">
                        <c:v>190</c:v>
                      </c:pt>
                      <c:pt idx="56">
                        <c:v>193</c:v>
                      </c:pt>
                      <c:pt idx="57">
                        <c:v>196</c:v>
                      </c:pt>
                      <c:pt idx="58">
                        <c:v>199</c:v>
                      </c:pt>
                      <c:pt idx="59">
                        <c:v>203</c:v>
                      </c:pt>
                      <c:pt idx="60">
                        <c:v>206</c:v>
                      </c:pt>
                      <c:pt idx="61">
                        <c:v>210</c:v>
                      </c:pt>
                      <c:pt idx="62">
                        <c:v>213</c:v>
                      </c:pt>
                      <c:pt idx="63">
                        <c:v>217</c:v>
                      </c:pt>
                      <c:pt idx="64">
                        <c:v>220</c:v>
                      </c:pt>
                      <c:pt idx="65">
                        <c:v>224</c:v>
                      </c:pt>
                      <c:pt idx="66">
                        <c:v>227</c:v>
                      </c:pt>
                      <c:pt idx="67">
                        <c:v>231</c:v>
                      </c:pt>
                      <c:pt idx="68">
                        <c:v>234</c:v>
                      </c:pt>
                      <c:pt idx="69">
                        <c:v>238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219 AZD_ AZDH3'!$B$2:$B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264.24</c:v>
                      </c:pt>
                      <c:pt idx="1">
                        <c:v>247.57</c:v>
                      </c:pt>
                      <c:pt idx="2">
                        <c:v>165.38</c:v>
                      </c:pt>
                      <c:pt idx="3">
                        <c:v>147.6</c:v>
                      </c:pt>
                      <c:pt idx="4">
                        <c:v>113.44</c:v>
                      </c:pt>
                      <c:pt idx="5">
                        <c:v>62.96</c:v>
                      </c:pt>
                      <c:pt idx="6">
                        <c:v>51.16</c:v>
                      </c:pt>
                      <c:pt idx="7">
                        <c:v>41.07</c:v>
                      </c:pt>
                      <c:pt idx="8">
                        <c:v>36.1</c:v>
                      </c:pt>
                      <c:pt idx="9">
                        <c:v>32.14</c:v>
                      </c:pt>
                      <c:pt idx="10">
                        <c:v>23.55</c:v>
                      </c:pt>
                      <c:pt idx="11">
                        <c:v>20.25</c:v>
                      </c:pt>
                      <c:pt idx="12">
                        <c:v>18.079999999999998</c:v>
                      </c:pt>
                      <c:pt idx="13">
                        <c:v>15.31</c:v>
                      </c:pt>
                      <c:pt idx="14">
                        <c:v>14.58</c:v>
                      </c:pt>
                      <c:pt idx="15">
                        <c:v>23.06</c:v>
                      </c:pt>
                      <c:pt idx="16">
                        <c:v>22.1</c:v>
                      </c:pt>
                      <c:pt idx="17">
                        <c:v>19.350000000000001</c:v>
                      </c:pt>
                      <c:pt idx="18">
                        <c:v>18.45</c:v>
                      </c:pt>
                      <c:pt idx="19">
                        <c:v>16.82</c:v>
                      </c:pt>
                      <c:pt idx="20">
                        <c:v>36</c:v>
                      </c:pt>
                      <c:pt idx="21">
                        <c:v>27.74</c:v>
                      </c:pt>
                      <c:pt idx="22">
                        <c:v>23.55</c:v>
                      </c:pt>
                      <c:pt idx="23">
                        <c:v>20.25</c:v>
                      </c:pt>
                      <c:pt idx="24">
                        <c:v>18.079999999999998</c:v>
                      </c:pt>
                      <c:pt idx="25">
                        <c:v>15.31</c:v>
                      </c:pt>
                      <c:pt idx="26">
                        <c:v>14.58</c:v>
                      </c:pt>
                      <c:pt idx="27">
                        <c:v>14.22</c:v>
                      </c:pt>
                      <c:pt idx="28">
                        <c:v>13.18</c:v>
                      </c:pt>
                      <c:pt idx="29">
                        <c:v>11.88</c:v>
                      </c:pt>
                      <c:pt idx="30">
                        <c:v>10.66</c:v>
                      </c:pt>
                      <c:pt idx="31">
                        <c:v>10.37</c:v>
                      </c:pt>
                      <c:pt idx="32">
                        <c:v>9.7899999999999991</c:v>
                      </c:pt>
                      <c:pt idx="33">
                        <c:v>9.7899999999999991</c:v>
                      </c:pt>
                      <c:pt idx="34">
                        <c:v>9.7899999999999991</c:v>
                      </c:pt>
                      <c:pt idx="35">
                        <c:v>9.2200000000000006</c:v>
                      </c:pt>
                      <c:pt idx="36">
                        <c:v>9.2200000000000006</c:v>
                      </c:pt>
                      <c:pt idx="38">
                        <c:v>11.15</c:v>
                      </c:pt>
                      <c:pt idx="39">
                        <c:v>12.76</c:v>
                      </c:pt>
                      <c:pt idx="40">
                        <c:v>13.72</c:v>
                      </c:pt>
                      <c:pt idx="41">
                        <c:v>15.3</c:v>
                      </c:pt>
                      <c:pt idx="42">
                        <c:v>17.3</c:v>
                      </c:pt>
                      <c:pt idx="43">
                        <c:v>21.24</c:v>
                      </c:pt>
                      <c:pt idx="44">
                        <c:v>26.95</c:v>
                      </c:pt>
                      <c:pt idx="45">
                        <c:v>37.54</c:v>
                      </c:pt>
                      <c:pt idx="46">
                        <c:v>46.23</c:v>
                      </c:pt>
                      <c:pt idx="47">
                        <c:v>61.06</c:v>
                      </c:pt>
                      <c:pt idx="48">
                        <c:v>70</c:v>
                      </c:pt>
                      <c:pt idx="49">
                        <c:v>88.94</c:v>
                      </c:pt>
                      <c:pt idx="50">
                        <c:v>95.29</c:v>
                      </c:pt>
                      <c:pt idx="51">
                        <c:v>103.97</c:v>
                      </c:pt>
                      <c:pt idx="52">
                        <c:v>122.4</c:v>
                      </c:pt>
                      <c:pt idx="53">
                        <c:v>130.24</c:v>
                      </c:pt>
                      <c:pt idx="54">
                        <c:v>140.31</c:v>
                      </c:pt>
                      <c:pt idx="55">
                        <c:v>146.85</c:v>
                      </c:pt>
                      <c:pt idx="56">
                        <c:v>152.81</c:v>
                      </c:pt>
                      <c:pt idx="57">
                        <c:v>159.74</c:v>
                      </c:pt>
                      <c:pt idx="58">
                        <c:v>164.78</c:v>
                      </c:pt>
                      <c:pt idx="59">
                        <c:v>179.56</c:v>
                      </c:pt>
                      <c:pt idx="60">
                        <c:v>187.27</c:v>
                      </c:pt>
                      <c:pt idx="61">
                        <c:v>200.9</c:v>
                      </c:pt>
                      <c:pt idx="62">
                        <c:v>207.36</c:v>
                      </c:pt>
                      <c:pt idx="63">
                        <c:v>227.25</c:v>
                      </c:pt>
                      <c:pt idx="64">
                        <c:v>237.14</c:v>
                      </c:pt>
                    </c:numCache>
                  </c:numRef>
                </c:yVal>
                <c:smooth val="1"/>
                <c:extLst>
                  <c:ext xmlns:c16="http://schemas.microsoft.com/office/drawing/2014/chart" uri="{C3380CC4-5D6E-409C-BE32-E72D297353CC}">
                    <c16:uniqueId val="{00000006-BA24-4D66-A2FF-BADC1EAEE179}"/>
                  </c:ext>
                </c:extLst>
              </c15:ser>
            </c15:filteredScatterSeries>
            <c15:filteredScatterSeries>
              <c15:ser>
                <c:idx val="1"/>
                <c:order val="1"/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A$2:$A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  <c:pt idx="31">
                        <c:v>107</c:v>
                      </c:pt>
                      <c:pt idx="32">
                        <c:v>111</c:v>
                      </c:pt>
                      <c:pt idx="33">
                        <c:v>114</c:v>
                      </c:pt>
                      <c:pt idx="34">
                        <c:v>118</c:v>
                      </c:pt>
                      <c:pt idx="35">
                        <c:v>121</c:v>
                      </c:pt>
                      <c:pt idx="36">
                        <c:v>125</c:v>
                      </c:pt>
                      <c:pt idx="38">
                        <c:v>128</c:v>
                      </c:pt>
                      <c:pt idx="39">
                        <c:v>132</c:v>
                      </c:pt>
                      <c:pt idx="40">
                        <c:v>135</c:v>
                      </c:pt>
                      <c:pt idx="41">
                        <c:v>141</c:v>
                      </c:pt>
                      <c:pt idx="42">
                        <c:v>144</c:v>
                      </c:pt>
                      <c:pt idx="43">
                        <c:v>148</c:v>
                      </c:pt>
                      <c:pt idx="44">
                        <c:v>151</c:v>
                      </c:pt>
                      <c:pt idx="45">
                        <c:v>155</c:v>
                      </c:pt>
                      <c:pt idx="46">
                        <c:v>158</c:v>
                      </c:pt>
                      <c:pt idx="47">
                        <c:v>162</c:v>
                      </c:pt>
                      <c:pt idx="48">
                        <c:v>165</c:v>
                      </c:pt>
                      <c:pt idx="49">
                        <c:v>169</c:v>
                      </c:pt>
                      <c:pt idx="50">
                        <c:v>172</c:v>
                      </c:pt>
                      <c:pt idx="51">
                        <c:v>176</c:v>
                      </c:pt>
                      <c:pt idx="52">
                        <c:v>179</c:v>
                      </c:pt>
                      <c:pt idx="53">
                        <c:v>183</c:v>
                      </c:pt>
                      <c:pt idx="54">
                        <c:v>186</c:v>
                      </c:pt>
                      <c:pt idx="55">
                        <c:v>190</c:v>
                      </c:pt>
                      <c:pt idx="56">
                        <c:v>193</c:v>
                      </c:pt>
                      <c:pt idx="57">
                        <c:v>196</c:v>
                      </c:pt>
                      <c:pt idx="58">
                        <c:v>199</c:v>
                      </c:pt>
                      <c:pt idx="59">
                        <c:v>203</c:v>
                      </c:pt>
                      <c:pt idx="60">
                        <c:v>206</c:v>
                      </c:pt>
                      <c:pt idx="61">
                        <c:v>210</c:v>
                      </c:pt>
                      <c:pt idx="62">
                        <c:v>213</c:v>
                      </c:pt>
                      <c:pt idx="63">
                        <c:v>217</c:v>
                      </c:pt>
                      <c:pt idx="64">
                        <c:v>220</c:v>
                      </c:pt>
                      <c:pt idx="65">
                        <c:v>224</c:v>
                      </c:pt>
                      <c:pt idx="66">
                        <c:v>227</c:v>
                      </c:pt>
                      <c:pt idx="67">
                        <c:v>231</c:v>
                      </c:pt>
                      <c:pt idx="68">
                        <c:v>234</c:v>
                      </c:pt>
                      <c:pt idx="69">
                        <c:v>23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C$2:$C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249.95</c:v>
                      </c:pt>
                      <c:pt idx="1">
                        <c:v>202.75</c:v>
                      </c:pt>
                      <c:pt idx="2">
                        <c:v>149.68</c:v>
                      </c:pt>
                      <c:pt idx="3">
                        <c:v>129.96</c:v>
                      </c:pt>
                      <c:pt idx="4">
                        <c:v>105.34</c:v>
                      </c:pt>
                      <c:pt idx="5">
                        <c:v>62.43</c:v>
                      </c:pt>
                      <c:pt idx="6">
                        <c:v>49.92</c:v>
                      </c:pt>
                      <c:pt idx="7">
                        <c:v>38.79</c:v>
                      </c:pt>
                      <c:pt idx="8">
                        <c:v>32.86</c:v>
                      </c:pt>
                      <c:pt idx="9">
                        <c:v>27.56</c:v>
                      </c:pt>
                      <c:pt idx="10">
                        <c:v>24.28</c:v>
                      </c:pt>
                      <c:pt idx="11">
                        <c:v>21.78</c:v>
                      </c:pt>
                      <c:pt idx="12">
                        <c:v>18.260000000000002</c:v>
                      </c:pt>
                      <c:pt idx="13">
                        <c:v>11.83</c:v>
                      </c:pt>
                      <c:pt idx="14">
                        <c:v>10.63</c:v>
                      </c:pt>
                      <c:pt idx="15">
                        <c:v>10</c:v>
                      </c:pt>
                      <c:pt idx="16">
                        <c:v>9.3800000000000008</c:v>
                      </c:pt>
                      <c:pt idx="17">
                        <c:v>8.75</c:v>
                      </c:pt>
                      <c:pt idx="18">
                        <c:v>6.29</c:v>
                      </c:pt>
                      <c:pt idx="19">
                        <c:v>5.29</c:v>
                      </c:pt>
                      <c:pt idx="20">
                        <c:v>4.8499999999999996</c:v>
                      </c:pt>
                      <c:pt idx="21">
                        <c:v>4.2</c:v>
                      </c:pt>
                      <c:pt idx="22">
                        <c:v>4.2</c:v>
                      </c:pt>
                      <c:pt idx="23">
                        <c:v>4.2</c:v>
                      </c:pt>
                      <c:pt idx="24">
                        <c:v>4</c:v>
                      </c:pt>
                      <c:pt idx="25">
                        <c:v>4</c:v>
                      </c:pt>
                      <c:pt idx="26">
                        <c:v>1.91</c:v>
                      </c:pt>
                      <c:pt idx="27">
                        <c:v>1.91</c:v>
                      </c:pt>
                      <c:pt idx="28">
                        <c:v>1.91</c:v>
                      </c:pt>
                      <c:pt idx="29">
                        <c:v>1.47</c:v>
                      </c:pt>
                      <c:pt idx="30">
                        <c:v>1.47</c:v>
                      </c:pt>
                      <c:pt idx="31">
                        <c:v>1.08</c:v>
                      </c:pt>
                      <c:pt idx="32">
                        <c:v>1.01</c:v>
                      </c:pt>
                      <c:pt idx="33">
                        <c:v>0.94</c:v>
                      </c:pt>
                      <c:pt idx="34">
                        <c:v>0.86</c:v>
                      </c:pt>
                      <c:pt idx="35">
                        <c:v>0.6</c:v>
                      </c:pt>
                      <c:pt idx="36">
                        <c:v>0.6</c:v>
                      </c:pt>
                      <c:pt idx="38">
                        <c:v>0.55000000000000004</c:v>
                      </c:pt>
                      <c:pt idx="39">
                        <c:v>0.55000000000000004</c:v>
                      </c:pt>
                      <c:pt idx="40">
                        <c:v>0.55000000000000004</c:v>
                      </c:pt>
                      <c:pt idx="41">
                        <c:v>0.73</c:v>
                      </c:pt>
                      <c:pt idx="42">
                        <c:v>0.73</c:v>
                      </c:pt>
                      <c:pt idx="43">
                        <c:v>1.01</c:v>
                      </c:pt>
                      <c:pt idx="44">
                        <c:v>1.08</c:v>
                      </c:pt>
                      <c:pt idx="45">
                        <c:v>1.27</c:v>
                      </c:pt>
                      <c:pt idx="46">
                        <c:v>1.35</c:v>
                      </c:pt>
                      <c:pt idx="47">
                        <c:v>1.44</c:v>
                      </c:pt>
                      <c:pt idx="48">
                        <c:v>1.44</c:v>
                      </c:pt>
                      <c:pt idx="49">
                        <c:v>1.44</c:v>
                      </c:pt>
                      <c:pt idx="50">
                        <c:v>1.44</c:v>
                      </c:pt>
                      <c:pt idx="51">
                        <c:v>1.44</c:v>
                      </c:pt>
                      <c:pt idx="52">
                        <c:v>1.44</c:v>
                      </c:pt>
                      <c:pt idx="53">
                        <c:v>1.44</c:v>
                      </c:pt>
                      <c:pt idx="54">
                        <c:v>1.44</c:v>
                      </c:pt>
                      <c:pt idx="55">
                        <c:v>1.44</c:v>
                      </c:pt>
                      <c:pt idx="56">
                        <c:v>1.35</c:v>
                      </c:pt>
                      <c:pt idx="57">
                        <c:v>1.35</c:v>
                      </c:pt>
                      <c:pt idx="58">
                        <c:v>1.35</c:v>
                      </c:pt>
                      <c:pt idx="59">
                        <c:v>1.35</c:v>
                      </c:pt>
                      <c:pt idx="60">
                        <c:v>1.35</c:v>
                      </c:pt>
                      <c:pt idx="61">
                        <c:v>1.35</c:v>
                      </c:pt>
                      <c:pt idx="62">
                        <c:v>1.35</c:v>
                      </c:pt>
                      <c:pt idx="63">
                        <c:v>1.35</c:v>
                      </c:pt>
                      <c:pt idx="64">
                        <c:v>1.35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BA24-4D66-A2FF-BADC1EAEE179}"/>
                  </c:ext>
                </c:extLst>
              </c15:ser>
            </c15:filteredScatterSeries>
            <c15:filteredScatterSeries>
              <c15:ser>
                <c:idx val="2"/>
                <c:order val="2"/>
                <c:spPr>
                  <a:ln w="19050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A$2:$A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  <c:pt idx="31">
                        <c:v>107</c:v>
                      </c:pt>
                      <c:pt idx="32">
                        <c:v>111</c:v>
                      </c:pt>
                      <c:pt idx="33">
                        <c:v>114</c:v>
                      </c:pt>
                      <c:pt idx="34">
                        <c:v>118</c:v>
                      </c:pt>
                      <c:pt idx="35">
                        <c:v>121</c:v>
                      </c:pt>
                      <c:pt idx="36">
                        <c:v>125</c:v>
                      </c:pt>
                      <c:pt idx="38">
                        <c:v>128</c:v>
                      </c:pt>
                      <c:pt idx="39">
                        <c:v>132</c:v>
                      </c:pt>
                      <c:pt idx="40">
                        <c:v>135</c:v>
                      </c:pt>
                      <c:pt idx="41">
                        <c:v>141</c:v>
                      </c:pt>
                      <c:pt idx="42">
                        <c:v>144</c:v>
                      </c:pt>
                      <c:pt idx="43">
                        <c:v>148</c:v>
                      </c:pt>
                      <c:pt idx="44">
                        <c:v>151</c:v>
                      </c:pt>
                      <c:pt idx="45">
                        <c:v>155</c:v>
                      </c:pt>
                      <c:pt idx="46">
                        <c:v>158</c:v>
                      </c:pt>
                      <c:pt idx="47">
                        <c:v>162</c:v>
                      </c:pt>
                      <c:pt idx="48">
                        <c:v>165</c:v>
                      </c:pt>
                      <c:pt idx="49">
                        <c:v>169</c:v>
                      </c:pt>
                      <c:pt idx="50">
                        <c:v>172</c:v>
                      </c:pt>
                      <c:pt idx="51">
                        <c:v>176</c:v>
                      </c:pt>
                      <c:pt idx="52">
                        <c:v>179</c:v>
                      </c:pt>
                      <c:pt idx="53">
                        <c:v>183</c:v>
                      </c:pt>
                      <c:pt idx="54">
                        <c:v>186</c:v>
                      </c:pt>
                      <c:pt idx="55">
                        <c:v>190</c:v>
                      </c:pt>
                      <c:pt idx="56">
                        <c:v>193</c:v>
                      </c:pt>
                      <c:pt idx="57">
                        <c:v>196</c:v>
                      </c:pt>
                      <c:pt idx="58">
                        <c:v>199</c:v>
                      </c:pt>
                      <c:pt idx="59">
                        <c:v>203</c:v>
                      </c:pt>
                      <c:pt idx="60">
                        <c:v>206</c:v>
                      </c:pt>
                      <c:pt idx="61">
                        <c:v>210</c:v>
                      </c:pt>
                      <c:pt idx="62">
                        <c:v>213</c:v>
                      </c:pt>
                      <c:pt idx="63">
                        <c:v>217</c:v>
                      </c:pt>
                      <c:pt idx="64">
                        <c:v>220</c:v>
                      </c:pt>
                      <c:pt idx="65">
                        <c:v>224</c:v>
                      </c:pt>
                      <c:pt idx="66">
                        <c:v>227</c:v>
                      </c:pt>
                      <c:pt idx="67">
                        <c:v>231</c:v>
                      </c:pt>
                      <c:pt idx="68">
                        <c:v>234</c:v>
                      </c:pt>
                      <c:pt idx="69">
                        <c:v>23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D$2:$D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257.08999999999997</c:v>
                      </c:pt>
                      <c:pt idx="1">
                        <c:v>215.04</c:v>
                      </c:pt>
                      <c:pt idx="2">
                        <c:v>165.58</c:v>
                      </c:pt>
                      <c:pt idx="3">
                        <c:v>99.14</c:v>
                      </c:pt>
                      <c:pt idx="4">
                        <c:v>96.77</c:v>
                      </c:pt>
                      <c:pt idx="5">
                        <c:v>69.63</c:v>
                      </c:pt>
                      <c:pt idx="6">
                        <c:v>64.510000000000005</c:v>
                      </c:pt>
                      <c:pt idx="7">
                        <c:v>57.13</c:v>
                      </c:pt>
                      <c:pt idx="8">
                        <c:v>52.65</c:v>
                      </c:pt>
                      <c:pt idx="9">
                        <c:v>48.4</c:v>
                      </c:pt>
                      <c:pt idx="10">
                        <c:v>45.3</c:v>
                      </c:pt>
                      <c:pt idx="11">
                        <c:v>34.229999999999997</c:v>
                      </c:pt>
                      <c:pt idx="12">
                        <c:v>31.1</c:v>
                      </c:pt>
                      <c:pt idx="13">
                        <c:v>25.11</c:v>
                      </c:pt>
                      <c:pt idx="14">
                        <c:v>21.78</c:v>
                      </c:pt>
                      <c:pt idx="15">
                        <c:v>18.940000000000001</c:v>
                      </c:pt>
                      <c:pt idx="16">
                        <c:v>17.41</c:v>
                      </c:pt>
                      <c:pt idx="17">
                        <c:v>14.4</c:v>
                      </c:pt>
                      <c:pt idx="18">
                        <c:v>13.04</c:v>
                      </c:pt>
                      <c:pt idx="19">
                        <c:v>11.76</c:v>
                      </c:pt>
                      <c:pt idx="20">
                        <c:v>10.34</c:v>
                      </c:pt>
                      <c:pt idx="21">
                        <c:v>9.06</c:v>
                      </c:pt>
                      <c:pt idx="22">
                        <c:v>8.75</c:v>
                      </c:pt>
                      <c:pt idx="23">
                        <c:v>7.49</c:v>
                      </c:pt>
                      <c:pt idx="24">
                        <c:v>7.49</c:v>
                      </c:pt>
                      <c:pt idx="25">
                        <c:v>7.06</c:v>
                      </c:pt>
                      <c:pt idx="26">
                        <c:v>6.84</c:v>
                      </c:pt>
                      <c:pt idx="27">
                        <c:v>6.62</c:v>
                      </c:pt>
                      <c:pt idx="28">
                        <c:v>6.39</c:v>
                      </c:pt>
                      <c:pt idx="29">
                        <c:v>6.17</c:v>
                      </c:pt>
                      <c:pt idx="30">
                        <c:v>5.95</c:v>
                      </c:pt>
                      <c:pt idx="31">
                        <c:v>5.73</c:v>
                      </c:pt>
                      <c:pt idx="32">
                        <c:v>5.51</c:v>
                      </c:pt>
                      <c:pt idx="33">
                        <c:v>5.51</c:v>
                      </c:pt>
                      <c:pt idx="34">
                        <c:v>5</c:v>
                      </c:pt>
                      <c:pt idx="35">
                        <c:v>4.4000000000000004</c:v>
                      </c:pt>
                      <c:pt idx="36">
                        <c:v>4.2</c:v>
                      </c:pt>
                      <c:pt idx="38">
                        <c:v>4</c:v>
                      </c:pt>
                      <c:pt idx="39">
                        <c:v>6.61</c:v>
                      </c:pt>
                      <c:pt idx="40">
                        <c:v>6.88</c:v>
                      </c:pt>
                      <c:pt idx="41">
                        <c:v>10.48</c:v>
                      </c:pt>
                      <c:pt idx="42">
                        <c:v>11.15</c:v>
                      </c:pt>
                      <c:pt idx="43">
                        <c:v>12.76</c:v>
                      </c:pt>
                      <c:pt idx="44">
                        <c:v>15.56</c:v>
                      </c:pt>
                      <c:pt idx="45">
                        <c:v>24.85</c:v>
                      </c:pt>
                      <c:pt idx="46">
                        <c:v>27.74</c:v>
                      </c:pt>
                      <c:pt idx="47">
                        <c:v>37.26</c:v>
                      </c:pt>
                      <c:pt idx="48">
                        <c:v>42.03</c:v>
                      </c:pt>
                      <c:pt idx="49">
                        <c:v>49.37</c:v>
                      </c:pt>
                      <c:pt idx="50">
                        <c:v>57.43</c:v>
                      </c:pt>
                      <c:pt idx="51">
                        <c:v>65</c:v>
                      </c:pt>
                      <c:pt idx="52">
                        <c:v>71.66</c:v>
                      </c:pt>
                      <c:pt idx="53">
                        <c:v>87.08</c:v>
                      </c:pt>
                      <c:pt idx="54">
                        <c:v>93.31</c:v>
                      </c:pt>
                      <c:pt idx="55">
                        <c:v>109.76</c:v>
                      </c:pt>
                      <c:pt idx="56">
                        <c:v>116.96</c:v>
                      </c:pt>
                      <c:pt idx="57">
                        <c:v>129.51</c:v>
                      </c:pt>
                      <c:pt idx="58">
                        <c:v>136.24</c:v>
                      </c:pt>
                      <c:pt idx="59">
                        <c:v>140.97999999999999</c:v>
                      </c:pt>
                      <c:pt idx="60">
                        <c:v>142.72</c:v>
                      </c:pt>
                      <c:pt idx="61">
                        <c:v>149.4</c:v>
                      </c:pt>
                      <c:pt idx="62">
                        <c:v>153.76</c:v>
                      </c:pt>
                      <c:pt idx="63">
                        <c:v>167.94</c:v>
                      </c:pt>
                      <c:pt idx="64">
                        <c:v>174.08</c:v>
                      </c:pt>
                      <c:pt idx="65">
                        <c:v>183.79</c:v>
                      </c:pt>
                      <c:pt idx="66">
                        <c:v>193.84</c:v>
                      </c:pt>
                      <c:pt idx="67">
                        <c:v>202.01</c:v>
                      </c:pt>
                      <c:pt idx="68">
                        <c:v>217.33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8-BA24-4D66-A2FF-BADC1EAEE179}"/>
                  </c:ext>
                </c:extLst>
              </c15:ser>
            </c15:filteredScatterSeries>
            <c15:filteredScatterSeries>
              <c15:ser>
                <c:idx val="3"/>
                <c:order val="3"/>
                <c:spPr>
                  <a:ln w="19050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A$2:$A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  <c:pt idx="31">
                        <c:v>107</c:v>
                      </c:pt>
                      <c:pt idx="32">
                        <c:v>111</c:v>
                      </c:pt>
                      <c:pt idx="33">
                        <c:v>114</c:v>
                      </c:pt>
                      <c:pt idx="34">
                        <c:v>118</c:v>
                      </c:pt>
                      <c:pt idx="35">
                        <c:v>121</c:v>
                      </c:pt>
                      <c:pt idx="36">
                        <c:v>125</c:v>
                      </c:pt>
                      <c:pt idx="38">
                        <c:v>128</c:v>
                      </c:pt>
                      <c:pt idx="39">
                        <c:v>132</c:v>
                      </c:pt>
                      <c:pt idx="40">
                        <c:v>135</c:v>
                      </c:pt>
                      <c:pt idx="41">
                        <c:v>141</c:v>
                      </c:pt>
                      <c:pt idx="42">
                        <c:v>144</c:v>
                      </c:pt>
                      <c:pt idx="43">
                        <c:v>148</c:v>
                      </c:pt>
                      <c:pt idx="44">
                        <c:v>151</c:v>
                      </c:pt>
                      <c:pt idx="45">
                        <c:v>155</c:v>
                      </c:pt>
                      <c:pt idx="46">
                        <c:v>158</c:v>
                      </c:pt>
                      <c:pt idx="47">
                        <c:v>162</c:v>
                      </c:pt>
                      <c:pt idx="48">
                        <c:v>165</c:v>
                      </c:pt>
                      <c:pt idx="49">
                        <c:v>169</c:v>
                      </c:pt>
                      <c:pt idx="50">
                        <c:v>172</c:v>
                      </c:pt>
                      <c:pt idx="51">
                        <c:v>176</c:v>
                      </c:pt>
                      <c:pt idx="52">
                        <c:v>179</c:v>
                      </c:pt>
                      <c:pt idx="53">
                        <c:v>183</c:v>
                      </c:pt>
                      <c:pt idx="54">
                        <c:v>186</c:v>
                      </c:pt>
                      <c:pt idx="55">
                        <c:v>190</c:v>
                      </c:pt>
                      <c:pt idx="56">
                        <c:v>193</c:v>
                      </c:pt>
                      <c:pt idx="57">
                        <c:v>196</c:v>
                      </c:pt>
                      <c:pt idx="58">
                        <c:v>199</c:v>
                      </c:pt>
                      <c:pt idx="59">
                        <c:v>203</c:v>
                      </c:pt>
                      <c:pt idx="60">
                        <c:v>206</c:v>
                      </c:pt>
                      <c:pt idx="61">
                        <c:v>210</c:v>
                      </c:pt>
                      <c:pt idx="62">
                        <c:v>213</c:v>
                      </c:pt>
                      <c:pt idx="63">
                        <c:v>217</c:v>
                      </c:pt>
                      <c:pt idx="64">
                        <c:v>220</c:v>
                      </c:pt>
                      <c:pt idx="65">
                        <c:v>224</c:v>
                      </c:pt>
                      <c:pt idx="66">
                        <c:v>227</c:v>
                      </c:pt>
                      <c:pt idx="67">
                        <c:v>231</c:v>
                      </c:pt>
                      <c:pt idx="68">
                        <c:v>234</c:v>
                      </c:pt>
                      <c:pt idx="69">
                        <c:v>23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E$2:$E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427.65</c:v>
                      </c:pt>
                      <c:pt idx="1">
                        <c:v>414.3</c:v>
                      </c:pt>
                      <c:pt idx="2">
                        <c:v>372.09</c:v>
                      </c:pt>
                      <c:pt idx="3">
                        <c:v>248.83</c:v>
                      </c:pt>
                      <c:pt idx="4">
                        <c:v>217.33</c:v>
                      </c:pt>
                      <c:pt idx="5">
                        <c:v>154.80000000000001</c:v>
                      </c:pt>
                      <c:pt idx="6">
                        <c:v>123.87</c:v>
                      </c:pt>
                      <c:pt idx="7">
                        <c:v>108.15</c:v>
                      </c:pt>
                      <c:pt idx="8">
                        <c:v>86.44</c:v>
                      </c:pt>
                      <c:pt idx="9">
                        <c:v>71.790000000000006</c:v>
                      </c:pt>
                      <c:pt idx="10">
                        <c:v>61.76</c:v>
                      </c:pt>
                      <c:pt idx="11">
                        <c:v>55.18</c:v>
                      </c:pt>
                      <c:pt idx="12">
                        <c:v>43.71</c:v>
                      </c:pt>
                      <c:pt idx="13">
                        <c:v>38.270000000000003</c:v>
                      </c:pt>
                      <c:pt idx="14">
                        <c:v>34.229999999999997</c:v>
                      </c:pt>
                      <c:pt idx="15">
                        <c:v>29.4</c:v>
                      </c:pt>
                      <c:pt idx="16">
                        <c:v>26.59</c:v>
                      </c:pt>
                      <c:pt idx="17">
                        <c:v>25.43</c:v>
                      </c:pt>
                      <c:pt idx="18">
                        <c:v>25.43</c:v>
                      </c:pt>
                      <c:pt idx="19">
                        <c:v>23.7</c:v>
                      </c:pt>
                      <c:pt idx="20">
                        <c:v>23.12</c:v>
                      </c:pt>
                      <c:pt idx="21">
                        <c:v>21.24</c:v>
                      </c:pt>
                      <c:pt idx="22">
                        <c:v>19.600000000000001</c:v>
                      </c:pt>
                      <c:pt idx="23">
                        <c:v>18.510000000000002</c:v>
                      </c:pt>
                      <c:pt idx="24">
                        <c:v>16.34</c:v>
                      </c:pt>
                      <c:pt idx="25">
                        <c:v>12.94</c:v>
                      </c:pt>
                      <c:pt idx="26">
                        <c:v>12.64</c:v>
                      </c:pt>
                      <c:pt idx="27">
                        <c:v>12.15</c:v>
                      </c:pt>
                      <c:pt idx="28">
                        <c:v>12.15</c:v>
                      </c:pt>
                      <c:pt idx="29">
                        <c:v>12.15</c:v>
                      </c:pt>
                      <c:pt idx="30">
                        <c:v>11.3</c:v>
                      </c:pt>
                      <c:pt idx="31">
                        <c:v>11.3</c:v>
                      </c:pt>
                      <c:pt idx="32">
                        <c:v>10.94</c:v>
                      </c:pt>
                      <c:pt idx="33">
                        <c:v>10.94</c:v>
                      </c:pt>
                      <c:pt idx="34">
                        <c:v>10.94</c:v>
                      </c:pt>
                      <c:pt idx="35">
                        <c:v>10.94</c:v>
                      </c:pt>
                      <c:pt idx="36">
                        <c:v>14.72</c:v>
                      </c:pt>
                      <c:pt idx="38">
                        <c:v>18.43</c:v>
                      </c:pt>
                      <c:pt idx="39">
                        <c:v>21.39</c:v>
                      </c:pt>
                      <c:pt idx="40">
                        <c:v>30.32</c:v>
                      </c:pt>
                      <c:pt idx="41">
                        <c:v>42.34</c:v>
                      </c:pt>
                      <c:pt idx="42">
                        <c:v>62.21</c:v>
                      </c:pt>
                      <c:pt idx="43">
                        <c:v>81.93</c:v>
                      </c:pt>
                      <c:pt idx="44">
                        <c:v>106.62</c:v>
                      </c:pt>
                      <c:pt idx="45">
                        <c:v>146.85</c:v>
                      </c:pt>
                      <c:pt idx="46">
                        <c:v>156.33000000000001</c:v>
                      </c:pt>
                      <c:pt idx="47">
                        <c:v>175.07</c:v>
                      </c:pt>
                      <c:pt idx="48">
                        <c:v>187.27</c:v>
                      </c:pt>
                      <c:pt idx="49">
                        <c:v>198.45</c:v>
                      </c:pt>
                      <c:pt idx="50">
                        <c:v>217.73</c:v>
                      </c:pt>
                      <c:pt idx="51">
                        <c:v>238.21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BA24-4D66-A2FF-BADC1EAEE179}"/>
                  </c:ext>
                </c:extLst>
              </c15:ser>
            </c15:filteredScatterSeries>
            <c15:filteredScatterSeries>
              <c15:ser>
                <c:idx val="4"/>
                <c:order val="4"/>
                <c:spPr>
                  <a:ln w="19050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A$2:$A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  <c:pt idx="31">
                        <c:v>107</c:v>
                      </c:pt>
                      <c:pt idx="32">
                        <c:v>111</c:v>
                      </c:pt>
                      <c:pt idx="33">
                        <c:v>114</c:v>
                      </c:pt>
                      <c:pt idx="34">
                        <c:v>118</c:v>
                      </c:pt>
                      <c:pt idx="35">
                        <c:v>121</c:v>
                      </c:pt>
                      <c:pt idx="36">
                        <c:v>125</c:v>
                      </c:pt>
                      <c:pt idx="38">
                        <c:v>128</c:v>
                      </c:pt>
                      <c:pt idx="39">
                        <c:v>132</c:v>
                      </c:pt>
                      <c:pt idx="40">
                        <c:v>135</c:v>
                      </c:pt>
                      <c:pt idx="41">
                        <c:v>141</c:v>
                      </c:pt>
                      <c:pt idx="42">
                        <c:v>144</c:v>
                      </c:pt>
                      <c:pt idx="43">
                        <c:v>148</c:v>
                      </c:pt>
                      <c:pt idx="44">
                        <c:v>151</c:v>
                      </c:pt>
                      <c:pt idx="45">
                        <c:v>155</c:v>
                      </c:pt>
                      <c:pt idx="46">
                        <c:v>158</c:v>
                      </c:pt>
                      <c:pt idx="47">
                        <c:v>162</c:v>
                      </c:pt>
                      <c:pt idx="48">
                        <c:v>165</c:v>
                      </c:pt>
                      <c:pt idx="49">
                        <c:v>169</c:v>
                      </c:pt>
                      <c:pt idx="50">
                        <c:v>172</c:v>
                      </c:pt>
                      <c:pt idx="51">
                        <c:v>176</c:v>
                      </c:pt>
                      <c:pt idx="52">
                        <c:v>179</c:v>
                      </c:pt>
                      <c:pt idx="53">
                        <c:v>183</c:v>
                      </c:pt>
                      <c:pt idx="54">
                        <c:v>186</c:v>
                      </c:pt>
                      <c:pt idx="55">
                        <c:v>190</c:v>
                      </c:pt>
                      <c:pt idx="56">
                        <c:v>193</c:v>
                      </c:pt>
                      <c:pt idx="57">
                        <c:v>196</c:v>
                      </c:pt>
                      <c:pt idx="58">
                        <c:v>199</c:v>
                      </c:pt>
                      <c:pt idx="59">
                        <c:v>203</c:v>
                      </c:pt>
                      <c:pt idx="60">
                        <c:v>206</c:v>
                      </c:pt>
                      <c:pt idx="61">
                        <c:v>210</c:v>
                      </c:pt>
                      <c:pt idx="62">
                        <c:v>213</c:v>
                      </c:pt>
                      <c:pt idx="63">
                        <c:v>217</c:v>
                      </c:pt>
                      <c:pt idx="64">
                        <c:v>220</c:v>
                      </c:pt>
                      <c:pt idx="65">
                        <c:v>224</c:v>
                      </c:pt>
                      <c:pt idx="66">
                        <c:v>227</c:v>
                      </c:pt>
                      <c:pt idx="67">
                        <c:v>231</c:v>
                      </c:pt>
                      <c:pt idx="68">
                        <c:v>234</c:v>
                      </c:pt>
                      <c:pt idx="69">
                        <c:v>23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F$2:$F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348.48</c:v>
                      </c:pt>
                      <c:pt idx="1">
                        <c:v>284.8</c:v>
                      </c:pt>
                      <c:pt idx="2">
                        <c:v>216.76</c:v>
                      </c:pt>
                      <c:pt idx="3">
                        <c:v>187.31</c:v>
                      </c:pt>
                      <c:pt idx="4">
                        <c:v>128.80000000000001</c:v>
                      </c:pt>
                      <c:pt idx="5">
                        <c:v>104.36</c:v>
                      </c:pt>
                      <c:pt idx="6">
                        <c:v>90.4</c:v>
                      </c:pt>
                      <c:pt idx="7">
                        <c:v>70.27</c:v>
                      </c:pt>
                      <c:pt idx="8">
                        <c:v>82.47</c:v>
                      </c:pt>
                      <c:pt idx="9">
                        <c:v>65.66</c:v>
                      </c:pt>
                      <c:pt idx="10">
                        <c:v>55.69</c:v>
                      </c:pt>
                      <c:pt idx="11">
                        <c:v>46.75</c:v>
                      </c:pt>
                      <c:pt idx="12">
                        <c:v>40.799999999999997</c:v>
                      </c:pt>
                      <c:pt idx="13">
                        <c:v>38.03</c:v>
                      </c:pt>
                      <c:pt idx="14">
                        <c:v>34.979999999999997</c:v>
                      </c:pt>
                      <c:pt idx="15">
                        <c:v>31.05</c:v>
                      </c:pt>
                      <c:pt idx="16">
                        <c:v>25.11</c:v>
                      </c:pt>
                      <c:pt idx="17">
                        <c:v>23.12</c:v>
                      </c:pt>
                      <c:pt idx="18">
                        <c:v>14.4</c:v>
                      </c:pt>
                      <c:pt idx="19">
                        <c:v>14.4</c:v>
                      </c:pt>
                      <c:pt idx="20">
                        <c:v>13.95</c:v>
                      </c:pt>
                      <c:pt idx="21">
                        <c:v>13.95</c:v>
                      </c:pt>
                      <c:pt idx="22">
                        <c:v>13.95</c:v>
                      </c:pt>
                      <c:pt idx="23">
                        <c:v>13.95</c:v>
                      </c:pt>
                      <c:pt idx="24">
                        <c:v>13.95</c:v>
                      </c:pt>
                      <c:pt idx="25">
                        <c:v>13.95</c:v>
                      </c:pt>
                      <c:pt idx="26">
                        <c:v>13.95</c:v>
                      </c:pt>
                      <c:pt idx="27">
                        <c:v>13.95</c:v>
                      </c:pt>
                      <c:pt idx="28">
                        <c:v>30.8</c:v>
                      </c:pt>
                      <c:pt idx="29">
                        <c:v>28.05</c:v>
                      </c:pt>
                      <c:pt idx="30">
                        <c:v>26.57</c:v>
                      </c:pt>
                      <c:pt idx="31">
                        <c:v>25.11</c:v>
                      </c:pt>
                      <c:pt idx="32">
                        <c:v>25.11</c:v>
                      </c:pt>
                      <c:pt idx="33">
                        <c:v>25.11</c:v>
                      </c:pt>
                      <c:pt idx="34">
                        <c:v>31.06</c:v>
                      </c:pt>
                      <c:pt idx="35">
                        <c:v>31.94</c:v>
                      </c:pt>
                      <c:pt idx="36">
                        <c:v>34.4</c:v>
                      </c:pt>
                      <c:pt idx="38">
                        <c:v>38.659999999999997</c:v>
                      </c:pt>
                      <c:pt idx="39">
                        <c:v>42.24</c:v>
                      </c:pt>
                      <c:pt idx="40">
                        <c:v>47.15</c:v>
                      </c:pt>
                      <c:pt idx="41">
                        <c:v>52.65</c:v>
                      </c:pt>
                      <c:pt idx="42">
                        <c:v>64.83</c:v>
                      </c:pt>
                      <c:pt idx="43">
                        <c:v>84.56</c:v>
                      </c:pt>
                      <c:pt idx="44">
                        <c:v>92.51</c:v>
                      </c:pt>
                      <c:pt idx="45">
                        <c:v>109.65</c:v>
                      </c:pt>
                      <c:pt idx="46">
                        <c:v>121.09</c:v>
                      </c:pt>
                      <c:pt idx="47">
                        <c:v>141.31</c:v>
                      </c:pt>
                      <c:pt idx="48">
                        <c:v>161.16999999999999</c:v>
                      </c:pt>
                      <c:pt idx="49">
                        <c:v>180.92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A-BA24-4D66-A2FF-BADC1EAEE179}"/>
                  </c:ext>
                </c:extLst>
              </c15:ser>
            </c15:filteredScatterSeries>
            <c15:filteredScatterSeries>
              <c15:ser>
                <c:idx val="5"/>
                <c:order val="5"/>
                <c:spPr>
                  <a:ln w="19050" cap="rnd">
                    <a:solidFill>
                      <a:schemeClr val="accent6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/>
                    </a:solidFill>
                    <a:ln w="9525">
                      <a:solidFill>
                        <a:schemeClr val="accent6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A$2:$A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  <c:pt idx="31">
                        <c:v>107</c:v>
                      </c:pt>
                      <c:pt idx="32">
                        <c:v>111</c:v>
                      </c:pt>
                      <c:pt idx="33">
                        <c:v>114</c:v>
                      </c:pt>
                      <c:pt idx="34">
                        <c:v>118</c:v>
                      </c:pt>
                      <c:pt idx="35">
                        <c:v>121</c:v>
                      </c:pt>
                      <c:pt idx="36">
                        <c:v>125</c:v>
                      </c:pt>
                      <c:pt idx="38">
                        <c:v>128</c:v>
                      </c:pt>
                      <c:pt idx="39">
                        <c:v>132</c:v>
                      </c:pt>
                      <c:pt idx="40">
                        <c:v>135</c:v>
                      </c:pt>
                      <c:pt idx="41">
                        <c:v>141</c:v>
                      </c:pt>
                      <c:pt idx="42">
                        <c:v>144</c:v>
                      </c:pt>
                      <c:pt idx="43">
                        <c:v>148</c:v>
                      </c:pt>
                      <c:pt idx="44">
                        <c:v>151</c:v>
                      </c:pt>
                      <c:pt idx="45">
                        <c:v>155</c:v>
                      </c:pt>
                      <c:pt idx="46">
                        <c:v>158</c:v>
                      </c:pt>
                      <c:pt idx="47">
                        <c:v>162</c:v>
                      </c:pt>
                      <c:pt idx="48">
                        <c:v>165</c:v>
                      </c:pt>
                      <c:pt idx="49">
                        <c:v>169</c:v>
                      </c:pt>
                      <c:pt idx="50">
                        <c:v>172</c:v>
                      </c:pt>
                      <c:pt idx="51">
                        <c:v>176</c:v>
                      </c:pt>
                      <c:pt idx="52">
                        <c:v>179</c:v>
                      </c:pt>
                      <c:pt idx="53">
                        <c:v>183</c:v>
                      </c:pt>
                      <c:pt idx="54">
                        <c:v>186</c:v>
                      </c:pt>
                      <c:pt idx="55">
                        <c:v>190</c:v>
                      </c:pt>
                      <c:pt idx="56">
                        <c:v>193</c:v>
                      </c:pt>
                      <c:pt idx="57">
                        <c:v>196</c:v>
                      </c:pt>
                      <c:pt idx="58">
                        <c:v>199</c:v>
                      </c:pt>
                      <c:pt idx="59">
                        <c:v>203</c:v>
                      </c:pt>
                      <c:pt idx="60">
                        <c:v>206</c:v>
                      </c:pt>
                      <c:pt idx="61">
                        <c:v>210</c:v>
                      </c:pt>
                      <c:pt idx="62">
                        <c:v>213</c:v>
                      </c:pt>
                      <c:pt idx="63">
                        <c:v>217</c:v>
                      </c:pt>
                      <c:pt idx="64">
                        <c:v>220</c:v>
                      </c:pt>
                      <c:pt idx="65">
                        <c:v>224</c:v>
                      </c:pt>
                      <c:pt idx="66">
                        <c:v>227</c:v>
                      </c:pt>
                      <c:pt idx="67">
                        <c:v>231</c:v>
                      </c:pt>
                      <c:pt idx="68">
                        <c:v>234</c:v>
                      </c:pt>
                      <c:pt idx="69">
                        <c:v>23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G$2:$G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295.7</c:v>
                      </c:pt>
                      <c:pt idx="1">
                        <c:v>202.55</c:v>
                      </c:pt>
                      <c:pt idx="2">
                        <c:v>144.46</c:v>
                      </c:pt>
                      <c:pt idx="3">
                        <c:v>89.73</c:v>
                      </c:pt>
                      <c:pt idx="4">
                        <c:v>61.95</c:v>
                      </c:pt>
                      <c:pt idx="5">
                        <c:v>48</c:v>
                      </c:pt>
                      <c:pt idx="6">
                        <c:v>41.15</c:v>
                      </c:pt>
                      <c:pt idx="7">
                        <c:v>36.96</c:v>
                      </c:pt>
                      <c:pt idx="8">
                        <c:v>37.65</c:v>
                      </c:pt>
                      <c:pt idx="9">
                        <c:v>32.4</c:v>
                      </c:pt>
                      <c:pt idx="10">
                        <c:v>29.81</c:v>
                      </c:pt>
                      <c:pt idx="11">
                        <c:v>24.28</c:v>
                      </c:pt>
                      <c:pt idx="12">
                        <c:v>19.46</c:v>
                      </c:pt>
                      <c:pt idx="13">
                        <c:v>17.78</c:v>
                      </c:pt>
                      <c:pt idx="14">
                        <c:v>16.2</c:v>
                      </c:pt>
                      <c:pt idx="15">
                        <c:v>14.3</c:v>
                      </c:pt>
                      <c:pt idx="16">
                        <c:v>10.48</c:v>
                      </c:pt>
                      <c:pt idx="17">
                        <c:v>10.14</c:v>
                      </c:pt>
                      <c:pt idx="18">
                        <c:v>9.1300000000000008</c:v>
                      </c:pt>
                      <c:pt idx="19">
                        <c:v>9.1300000000000008</c:v>
                      </c:pt>
                      <c:pt idx="20">
                        <c:v>9.1300000000000008</c:v>
                      </c:pt>
                      <c:pt idx="21">
                        <c:v>8.44</c:v>
                      </c:pt>
                      <c:pt idx="22">
                        <c:v>8.44</c:v>
                      </c:pt>
                      <c:pt idx="23">
                        <c:v>8.1300000000000008</c:v>
                      </c:pt>
                      <c:pt idx="24">
                        <c:v>8.1300000000000008</c:v>
                      </c:pt>
                      <c:pt idx="25">
                        <c:v>7.49</c:v>
                      </c:pt>
                      <c:pt idx="26">
                        <c:v>7.49</c:v>
                      </c:pt>
                      <c:pt idx="27">
                        <c:v>7.49</c:v>
                      </c:pt>
                      <c:pt idx="28">
                        <c:v>6.35</c:v>
                      </c:pt>
                      <c:pt idx="29">
                        <c:v>5.81</c:v>
                      </c:pt>
                      <c:pt idx="30">
                        <c:v>5.81</c:v>
                      </c:pt>
                      <c:pt idx="31">
                        <c:v>5.81</c:v>
                      </c:pt>
                      <c:pt idx="32">
                        <c:v>5.29</c:v>
                      </c:pt>
                      <c:pt idx="33">
                        <c:v>4.8499999999999996</c:v>
                      </c:pt>
                      <c:pt idx="34">
                        <c:v>4.63</c:v>
                      </c:pt>
                      <c:pt idx="35">
                        <c:v>4.63</c:v>
                      </c:pt>
                      <c:pt idx="36">
                        <c:v>4.63</c:v>
                      </c:pt>
                      <c:pt idx="38">
                        <c:v>4.63</c:v>
                      </c:pt>
                      <c:pt idx="39">
                        <c:v>5.81</c:v>
                      </c:pt>
                      <c:pt idx="40">
                        <c:v>6.29</c:v>
                      </c:pt>
                      <c:pt idx="41">
                        <c:v>6.88</c:v>
                      </c:pt>
                      <c:pt idx="42">
                        <c:v>8.06</c:v>
                      </c:pt>
                      <c:pt idx="43">
                        <c:v>8.75</c:v>
                      </c:pt>
                      <c:pt idx="44">
                        <c:v>9.06</c:v>
                      </c:pt>
                      <c:pt idx="45">
                        <c:v>10.94</c:v>
                      </c:pt>
                      <c:pt idx="46">
                        <c:v>13.04</c:v>
                      </c:pt>
                      <c:pt idx="47">
                        <c:v>15.3</c:v>
                      </c:pt>
                      <c:pt idx="48">
                        <c:v>16.34</c:v>
                      </c:pt>
                      <c:pt idx="49">
                        <c:v>19.059999999999999</c:v>
                      </c:pt>
                      <c:pt idx="50">
                        <c:v>19.059999999999999</c:v>
                      </c:pt>
                      <c:pt idx="51">
                        <c:v>19.600000000000001</c:v>
                      </c:pt>
                      <c:pt idx="52">
                        <c:v>19.600000000000001</c:v>
                      </c:pt>
                      <c:pt idx="53">
                        <c:v>20.81</c:v>
                      </c:pt>
                      <c:pt idx="54">
                        <c:v>21.39</c:v>
                      </c:pt>
                      <c:pt idx="55">
                        <c:v>21.39</c:v>
                      </c:pt>
                      <c:pt idx="56">
                        <c:v>21.39</c:v>
                      </c:pt>
                      <c:pt idx="57">
                        <c:v>23.89</c:v>
                      </c:pt>
                      <c:pt idx="58">
                        <c:v>25.92</c:v>
                      </c:pt>
                      <c:pt idx="59">
                        <c:v>25.92</c:v>
                      </c:pt>
                      <c:pt idx="60">
                        <c:v>29.6</c:v>
                      </c:pt>
                      <c:pt idx="61">
                        <c:v>31.94</c:v>
                      </c:pt>
                      <c:pt idx="62">
                        <c:v>33.46</c:v>
                      </c:pt>
                      <c:pt idx="63">
                        <c:v>34.979999999999997</c:v>
                      </c:pt>
                      <c:pt idx="64">
                        <c:v>37.6</c:v>
                      </c:pt>
                      <c:pt idx="65">
                        <c:v>39.5</c:v>
                      </c:pt>
                      <c:pt idx="66">
                        <c:v>40.57</c:v>
                      </c:pt>
                      <c:pt idx="67">
                        <c:v>42.34</c:v>
                      </c:pt>
                      <c:pt idx="68">
                        <c:v>44.1</c:v>
                      </c:pt>
                      <c:pt idx="69">
                        <c:v>47.15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B-BA24-4D66-A2FF-BADC1EAEE179}"/>
                  </c:ext>
                </c:extLst>
              </c15:ser>
            </c15:filteredScatterSeries>
            <c15:filteredScatterSeries>
              <c15:ser>
                <c:idx val="6"/>
                <c:order val="6"/>
                <c:spPr>
                  <a:ln w="19050" cap="rnd">
                    <a:solidFill>
                      <a:schemeClr val="accent1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>
                        <a:lumMod val="60000"/>
                      </a:schemeClr>
                    </a:solidFill>
                    <a:ln w="9525">
                      <a:solidFill>
                        <a:schemeClr val="accent1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A$2:$A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  <c:pt idx="31">
                        <c:v>107</c:v>
                      </c:pt>
                      <c:pt idx="32">
                        <c:v>111</c:v>
                      </c:pt>
                      <c:pt idx="33">
                        <c:v>114</c:v>
                      </c:pt>
                      <c:pt idx="34">
                        <c:v>118</c:v>
                      </c:pt>
                      <c:pt idx="35">
                        <c:v>121</c:v>
                      </c:pt>
                      <c:pt idx="36">
                        <c:v>125</c:v>
                      </c:pt>
                      <c:pt idx="38">
                        <c:v>128</c:v>
                      </c:pt>
                      <c:pt idx="39">
                        <c:v>132</c:v>
                      </c:pt>
                      <c:pt idx="40">
                        <c:v>135</c:v>
                      </c:pt>
                      <c:pt idx="41">
                        <c:v>141</c:v>
                      </c:pt>
                      <c:pt idx="42">
                        <c:v>144</c:v>
                      </c:pt>
                      <c:pt idx="43">
                        <c:v>148</c:v>
                      </c:pt>
                      <c:pt idx="44">
                        <c:v>151</c:v>
                      </c:pt>
                      <c:pt idx="45">
                        <c:v>155</c:v>
                      </c:pt>
                      <c:pt idx="46">
                        <c:v>158</c:v>
                      </c:pt>
                      <c:pt idx="47">
                        <c:v>162</c:v>
                      </c:pt>
                      <c:pt idx="48">
                        <c:v>165</c:v>
                      </c:pt>
                      <c:pt idx="49">
                        <c:v>169</c:v>
                      </c:pt>
                      <c:pt idx="50">
                        <c:v>172</c:v>
                      </c:pt>
                      <c:pt idx="51">
                        <c:v>176</c:v>
                      </c:pt>
                      <c:pt idx="52">
                        <c:v>179</c:v>
                      </c:pt>
                      <c:pt idx="53">
                        <c:v>183</c:v>
                      </c:pt>
                      <c:pt idx="54">
                        <c:v>186</c:v>
                      </c:pt>
                      <c:pt idx="55">
                        <c:v>190</c:v>
                      </c:pt>
                      <c:pt idx="56">
                        <c:v>193</c:v>
                      </c:pt>
                      <c:pt idx="57">
                        <c:v>196</c:v>
                      </c:pt>
                      <c:pt idx="58">
                        <c:v>199</c:v>
                      </c:pt>
                      <c:pt idx="59">
                        <c:v>203</c:v>
                      </c:pt>
                      <c:pt idx="60">
                        <c:v>206</c:v>
                      </c:pt>
                      <c:pt idx="61">
                        <c:v>210</c:v>
                      </c:pt>
                      <c:pt idx="62">
                        <c:v>213</c:v>
                      </c:pt>
                      <c:pt idx="63">
                        <c:v>217</c:v>
                      </c:pt>
                      <c:pt idx="64">
                        <c:v>220</c:v>
                      </c:pt>
                      <c:pt idx="65">
                        <c:v>224</c:v>
                      </c:pt>
                      <c:pt idx="66">
                        <c:v>227</c:v>
                      </c:pt>
                      <c:pt idx="67">
                        <c:v>231</c:v>
                      </c:pt>
                      <c:pt idx="68">
                        <c:v>234</c:v>
                      </c:pt>
                      <c:pt idx="69">
                        <c:v>238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19 AZD_ AZDH3'!$H$2:$H$71</c15:sqref>
                        </c15:formulaRef>
                      </c:ext>
                    </c:extLst>
                    <c:numCache>
                      <c:formatCode>General</c:formatCode>
                      <c:ptCount val="70"/>
                      <c:pt idx="0">
                        <c:v>307.185</c:v>
                      </c:pt>
                      <c:pt idx="1">
                        <c:v>261.16833333333335</c:v>
                      </c:pt>
                      <c:pt idx="2">
                        <c:v>202.32500000000002</c:v>
                      </c:pt>
                      <c:pt idx="3">
                        <c:v>150.42833333333331</c:v>
                      </c:pt>
                      <c:pt idx="4">
                        <c:v>120.60500000000002</c:v>
                      </c:pt>
                      <c:pt idx="5">
                        <c:v>83.696666666666673</c:v>
                      </c:pt>
                      <c:pt idx="6">
                        <c:v>70.168333333333337</c:v>
                      </c:pt>
                      <c:pt idx="7">
                        <c:v>58.728333333333332</c:v>
                      </c:pt>
                      <c:pt idx="8">
                        <c:v>54.694999999999993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C-BA24-4D66-A2FF-BADC1EAEE179}"/>
                  </c:ext>
                </c:extLst>
              </c15:ser>
            </c15:filteredScatterSeries>
          </c:ext>
        </c:extLst>
      </c:scatterChart>
      <c:valAx>
        <c:axId val="1704913376"/>
        <c:scaling>
          <c:orientation val="minMax"/>
          <c:max val="1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Days after first dosing</a:t>
                </a:r>
              </a:p>
            </c:rich>
          </c:tx>
          <c:layout>
            <c:manualLayout>
              <c:xMode val="edge"/>
              <c:yMode val="edge"/>
              <c:x val="0.32222493554669518"/>
              <c:y val="0.934685167831457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04901312"/>
        <c:crosses val="autoZero"/>
        <c:crossBetween val="midCat"/>
      </c:valAx>
      <c:valAx>
        <c:axId val="17049013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>
                    <a:solidFill>
                      <a:sysClr val="windowText" lastClr="000000"/>
                    </a:solidFill>
                    <a:effectLst/>
                  </a:rPr>
                  <a:t>Tumor Volume (</a:t>
                </a:r>
                <a:r>
                  <a:rPr lang="en-US" sz="1200" b="1" i="0" baseline="0" err="1">
                    <a:solidFill>
                      <a:sysClr val="windowText" lastClr="000000"/>
                    </a:solidFill>
                    <a:effectLst/>
                  </a:rPr>
                  <a:t>mm3</a:t>
                </a:r>
                <a:r>
                  <a:rPr lang="en-US" sz="1200" b="1" i="0" baseline="0">
                    <a:solidFill>
                      <a:sysClr val="windowText" lastClr="000000"/>
                    </a:solidFill>
                    <a:effectLst/>
                  </a:rPr>
                  <a:t>) </a:t>
                </a:r>
                <a:endParaRPr lang="en-US" sz="1200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0"/>
              <c:y val="0.259442545689737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049133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accent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844670112470262"/>
          <c:y val="3.6767343136457027E-2"/>
          <c:w val="0.76358957898564561"/>
          <c:h val="0.8398648711679372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AZD+FcK'!$B$37</c:f>
              <c:strCache>
                <c:ptCount val="1"/>
                <c:pt idx="0">
                  <c:v>HGF #14 L (F)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AZD+FcK'!$A$38:$A$68</c:f>
              <c:numCache>
                <c:formatCode>General</c:formatCode>
                <c:ptCount val="31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</c:numCache>
            </c:numRef>
          </c:xVal>
          <c:yVal>
            <c:numRef>
              <c:f>'AZD+FcK'!$B$38:$B$68</c:f>
              <c:numCache>
                <c:formatCode>General</c:formatCode>
                <c:ptCount val="31"/>
                <c:pt idx="0">
                  <c:v>306.13</c:v>
                </c:pt>
                <c:pt idx="1">
                  <c:v>226.58</c:v>
                </c:pt>
                <c:pt idx="2">
                  <c:v>155.65</c:v>
                </c:pt>
                <c:pt idx="3">
                  <c:v>142.88</c:v>
                </c:pt>
                <c:pt idx="4">
                  <c:v>126.51</c:v>
                </c:pt>
                <c:pt idx="5">
                  <c:v>118.8</c:v>
                </c:pt>
                <c:pt idx="6">
                  <c:v>110.47</c:v>
                </c:pt>
                <c:pt idx="7">
                  <c:v>107.65</c:v>
                </c:pt>
                <c:pt idx="8">
                  <c:v>98.78</c:v>
                </c:pt>
                <c:pt idx="9">
                  <c:v>95.65</c:v>
                </c:pt>
                <c:pt idx="10">
                  <c:v>92.51</c:v>
                </c:pt>
                <c:pt idx="11">
                  <c:v>88.43</c:v>
                </c:pt>
                <c:pt idx="12">
                  <c:v>94.64</c:v>
                </c:pt>
                <c:pt idx="13">
                  <c:v>111.92</c:v>
                </c:pt>
                <c:pt idx="14">
                  <c:v>121.84</c:v>
                </c:pt>
                <c:pt idx="15">
                  <c:v>139.54</c:v>
                </c:pt>
                <c:pt idx="16">
                  <c:v>161.16999999999999</c:v>
                </c:pt>
                <c:pt idx="17">
                  <c:v>174.24</c:v>
                </c:pt>
                <c:pt idx="18">
                  <c:v>187.27</c:v>
                </c:pt>
                <c:pt idx="19">
                  <c:v>215.6</c:v>
                </c:pt>
                <c:pt idx="20">
                  <c:v>257.02999999999997</c:v>
                </c:pt>
                <c:pt idx="21">
                  <c:v>287.08999999999997</c:v>
                </c:pt>
                <c:pt idx="22">
                  <c:v>314.93</c:v>
                </c:pt>
                <c:pt idx="23">
                  <c:v>356.33</c:v>
                </c:pt>
                <c:pt idx="24">
                  <c:v>447.1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0B4-49A5-A90E-C973969B8D8B}"/>
            </c:ext>
          </c:extLst>
        </c:ser>
        <c:ser>
          <c:idx val="2"/>
          <c:order val="2"/>
          <c:tx>
            <c:strRef>
              <c:f>'AZD+FcK'!$D$37</c:f>
              <c:strCache>
                <c:ptCount val="1"/>
                <c:pt idx="0">
                  <c:v>HGF #15 L (F)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AZD+FcK'!$A$38:$A$68</c:f>
              <c:numCache>
                <c:formatCode>General</c:formatCode>
                <c:ptCount val="31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</c:numCache>
            </c:numRef>
          </c:xVal>
          <c:yVal>
            <c:numRef>
              <c:f>'AZD+FcK'!$D$38:$D$68</c:f>
              <c:numCache>
                <c:formatCode>General</c:formatCode>
                <c:ptCount val="31"/>
                <c:pt idx="0">
                  <c:v>316.22000000000003</c:v>
                </c:pt>
                <c:pt idx="1">
                  <c:v>274.73</c:v>
                </c:pt>
                <c:pt idx="2">
                  <c:v>234.49</c:v>
                </c:pt>
                <c:pt idx="3">
                  <c:v>189.77</c:v>
                </c:pt>
                <c:pt idx="4">
                  <c:v>93.64</c:v>
                </c:pt>
                <c:pt idx="5">
                  <c:v>78.290000000000006</c:v>
                </c:pt>
                <c:pt idx="6">
                  <c:v>62.36</c:v>
                </c:pt>
                <c:pt idx="7">
                  <c:v>61.6</c:v>
                </c:pt>
                <c:pt idx="8">
                  <c:v>58.48</c:v>
                </c:pt>
                <c:pt idx="9">
                  <c:v>57.76</c:v>
                </c:pt>
                <c:pt idx="10">
                  <c:v>57.8</c:v>
                </c:pt>
                <c:pt idx="11">
                  <c:v>56.32</c:v>
                </c:pt>
                <c:pt idx="12">
                  <c:v>55.47</c:v>
                </c:pt>
                <c:pt idx="13">
                  <c:v>60.8</c:v>
                </c:pt>
                <c:pt idx="14">
                  <c:v>67.760000000000005</c:v>
                </c:pt>
                <c:pt idx="15">
                  <c:v>97.5</c:v>
                </c:pt>
                <c:pt idx="16">
                  <c:v>106.81</c:v>
                </c:pt>
                <c:pt idx="17">
                  <c:v>116.64</c:v>
                </c:pt>
                <c:pt idx="18">
                  <c:v>125.54</c:v>
                </c:pt>
                <c:pt idx="19">
                  <c:v>157.4</c:v>
                </c:pt>
                <c:pt idx="20">
                  <c:v>174.9</c:v>
                </c:pt>
                <c:pt idx="21">
                  <c:v>190.78</c:v>
                </c:pt>
                <c:pt idx="22">
                  <c:v>240.43</c:v>
                </c:pt>
                <c:pt idx="23">
                  <c:v>269.57</c:v>
                </c:pt>
                <c:pt idx="24">
                  <c:v>290.23</c:v>
                </c:pt>
                <c:pt idx="25">
                  <c:v>337.95</c:v>
                </c:pt>
                <c:pt idx="26">
                  <c:v>390.4</c:v>
                </c:pt>
                <c:pt idx="27">
                  <c:v>435.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0B4-49A5-A90E-C973969B8D8B}"/>
            </c:ext>
          </c:extLst>
        </c:ser>
        <c:ser>
          <c:idx val="6"/>
          <c:order val="6"/>
          <c:tx>
            <c:strRef>
              <c:f>'AZD+FcK'!$H$37</c:f>
              <c:strCache>
                <c:ptCount val="1"/>
                <c:pt idx="0">
                  <c:v>HGF #31 L (F)</c:v>
                </c:pt>
              </c:strCache>
              <c:extLst xmlns:c15="http://schemas.microsoft.com/office/drawing/2012/chart"/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AZD+FcK'!$A$38:$A$68</c:f>
              <c:numCache>
                <c:formatCode>General</c:formatCode>
                <c:ptCount val="31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</c:numCache>
              <c:extLst xmlns:c15="http://schemas.microsoft.com/office/drawing/2012/chart"/>
            </c:numRef>
          </c:xVal>
          <c:yVal>
            <c:numRef>
              <c:f>'AZD+FcK'!$H$38:$H$68</c:f>
              <c:numCache>
                <c:formatCode>General</c:formatCode>
                <c:ptCount val="31"/>
                <c:pt idx="0">
                  <c:v>311.89999999999998</c:v>
                </c:pt>
                <c:pt idx="1">
                  <c:v>284.06</c:v>
                </c:pt>
                <c:pt idx="2">
                  <c:v>262.85000000000002</c:v>
                </c:pt>
                <c:pt idx="3">
                  <c:v>211.72</c:v>
                </c:pt>
                <c:pt idx="4">
                  <c:v>190.13</c:v>
                </c:pt>
                <c:pt idx="5">
                  <c:v>149.91999999999999</c:v>
                </c:pt>
                <c:pt idx="6">
                  <c:v>133.19999999999999</c:v>
                </c:pt>
                <c:pt idx="7">
                  <c:v>102.85</c:v>
                </c:pt>
                <c:pt idx="8">
                  <c:v>98.31</c:v>
                </c:pt>
                <c:pt idx="9">
                  <c:v>101.34</c:v>
                </c:pt>
                <c:pt idx="10">
                  <c:v>109.35</c:v>
                </c:pt>
                <c:pt idx="11">
                  <c:v>114.95</c:v>
                </c:pt>
                <c:pt idx="12">
                  <c:v>119.17</c:v>
                </c:pt>
                <c:pt idx="13">
                  <c:v>125.09</c:v>
                </c:pt>
              </c:numCache>
              <c:extLst xmlns:c15="http://schemas.microsoft.com/office/drawing/2012/chart"/>
            </c:numRef>
          </c:yVal>
          <c:smooth val="1"/>
          <c:extLst>
            <c:ext xmlns:c16="http://schemas.microsoft.com/office/drawing/2014/chart" uri="{C3380CC4-5D6E-409C-BE32-E72D297353CC}">
              <c16:uniqueId val="{00000008-10B4-49A5-A90E-C973969B8D8B}"/>
            </c:ext>
          </c:extLst>
        </c:ser>
        <c:ser>
          <c:idx val="8"/>
          <c:order val="8"/>
          <c:tx>
            <c:strRef>
              <c:f>'AZD+FcK'!$J$37</c:f>
              <c:strCache>
                <c:ptCount val="1"/>
                <c:pt idx="0">
                  <c:v>HGF #32 L (F)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'AZD+FcK'!$A$38:$A$68</c:f>
              <c:numCache>
                <c:formatCode>General</c:formatCode>
                <c:ptCount val="31"/>
                <c:pt idx="0">
                  <c:v>0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8</c:v>
                </c:pt>
                <c:pt idx="15">
                  <c:v>51</c:v>
                </c:pt>
                <c:pt idx="16">
                  <c:v>55</c:v>
                </c:pt>
                <c:pt idx="17">
                  <c:v>58</c:v>
                </c:pt>
                <c:pt idx="18">
                  <c:v>62</c:v>
                </c:pt>
                <c:pt idx="19">
                  <c:v>65</c:v>
                </c:pt>
                <c:pt idx="20">
                  <c:v>69</c:v>
                </c:pt>
                <c:pt idx="21">
                  <c:v>72</c:v>
                </c:pt>
                <c:pt idx="22">
                  <c:v>76</c:v>
                </c:pt>
                <c:pt idx="23">
                  <c:v>79</c:v>
                </c:pt>
                <c:pt idx="24">
                  <c:v>83</c:v>
                </c:pt>
                <c:pt idx="25">
                  <c:v>86</c:v>
                </c:pt>
                <c:pt idx="26">
                  <c:v>90</c:v>
                </c:pt>
                <c:pt idx="27">
                  <c:v>93</c:v>
                </c:pt>
                <c:pt idx="28">
                  <c:v>97</c:v>
                </c:pt>
                <c:pt idx="29">
                  <c:v>100</c:v>
                </c:pt>
                <c:pt idx="30">
                  <c:v>104</c:v>
                </c:pt>
              </c:numCache>
            </c:numRef>
          </c:xVal>
          <c:yVal>
            <c:numRef>
              <c:f>'AZD+FcK'!$J$38:$J$68</c:f>
              <c:numCache>
                <c:formatCode>General</c:formatCode>
                <c:ptCount val="31"/>
                <c:pt idx="0">
                  <c:v>355.22</c:v>
                </c:pt>
                <c:pt idx="1">
                  <c:v>295.49</c:v>
                </c:pt>
                <c:pt idx="2">
                  <c:v>262.14999999999998</c:v>
                </c:pt>
                <c:pt idx="3">
                  <c:v>215.04</c:v>
                </c:pt>
                <c:pt idx="4">
                  <c:v>188.53</c:v>
                </c:pt>
                <c:pt idx="5">
                  <c:v>142.97</c:v>
                </c:pt>
                <c:pt idx="6">
                  <c:v>116.27</c:v>
                </c:pt>
                <c:pt idx="7">
                  <c:v>128.56</c:v>
                </c:pt>
                <c:pt idx="8">
                  <c:v>142.69</c:v>
                </c:pt>
                <c:pt idx="9">
                  <c:v>152.69999999999999</c:v>
                </c:pt>
                <c:pt idx="10">
                  <c:v>161.47</c:v>
                </c:pt>
                <c:pt idx="11">
                  <c:v>176.4</c:v>
                </c:pt>
                <c:pt idx="12">
                  <c:v>202.42</c:v>
                </c:pt>
                <c:pt idx="13">
                  <c:v>233.43</c:v>
                </c:pt>
                <c:pt idx="14">
                  <c:v>264.64999999999998</c:v>
                </c:pt>
                <c:pt idx="15">
                  <c:v>287.77</c:v>
                </c:pt>
                <c:pt idx="16">
                  <c:v>306.66000000000003</c:v>
                </c:pt>
                <c:pt idx="17">
                  <c:v>343.88</c:v>
                </c:pt>
                <c:pt idx="18">
                  <c:v>377.21</c:v>
                </c:pt>
                <c:pt idx="19">
                  <c:v>425.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10B4-49A5-A90E-C973969B8D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95740992"/>
        <c:axId val="1395733792"/>
        <c:extLst>
          <c:ext xmlns:c15="http://schemas.microsoft.com/office/drawing/2012/chart" uri="{02D57815-91ED-43cb-92C2-25804820EDAC}">
            <c15:filteredScatterSeries>
              <c15:ser>
                <c:idx val="1"/>
                <c:order val="1"/>
                <c:tx>
                  <c:strRef>
                    <c:extLst>
                      <c:ext uri="{02D57815-91ED-43cb-92C2-25804820EDAC}">
                        <c15:formulaRef>
                          <c15:sqref>'AZD+FcK'!$C$37</c15:sqref>
                        </c15:formulaRef>
                      </c:ext>
                    </c:extLst>
                    <c:strCache>
                      <c:ptCount val="1"/>
                      <c:pt idx="0">
                        <c:v>HGF #14 R (F)</c:v>
                      </c:pt>
                    </c:strCache>
                  </c:strRef>
                </c:tx>
                <c:spPr>
                  <a:ln w="19050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AZD+FcK'!$A$38:$A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AZD+FcK'!$C$38:$C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127.01</c:v>
                      </c:pt>
                      <c:pt idx="1">
                        <c:v>138.6</c:v>
                      </c:pt>
                      <c:pt idx="2">
                        <c:v>123.87</c:v>
                      </c:pt>
                      <c:pt idx="3">
                        <c:v>91.04</c:v>
                      </c:pt>
                      <c:pt idx="4">
                        <c:v>63.79</c:v>
                      </c:pt>
                      <c:pt idx="5">
                        <c:v>119.42</c:v>
                      </c:pt>
                      <c:pt idx="6">
                        <c:v>103.49</c:v>
                      </c:pt>
                      <c:pt idx="7">
                        <c:v>73.75</c:v>
                      </c:pt>
                      <c:pt idx="8">
                        <c:v>59.25</c:v>
                      </c:pt>
                      <c:pt idx="9">
                        <c:v>48.07</c:v>
                      </c:pt>
                      <c:pt idx="10">
                        <c:v>40.799999999999997</c:v>
                      </c:pt>
                      <c:pt idx="11">
                        <c:v>33.93</c:v>
                      </c:pt>
                      <c:pt idx="12">
                        <c:v>28.51</c:v>
                      </c:pt>
                      <c:pt idx="13">
                        <c:v>23.12</c:v>
                      </c:pt>
                      <c:pt idx="14">
                        <c:v>17.100000000000001</c:v>
                      </c:pt>
                      <c:pt idx="15">
                        <c:v>17.100000000000001</c:v>
                      </c:pt>
                      <c:pt idx="16">
                        <c:v>17.100000000000001</c:v>
                      </c:pt>
                      <c:pt idx="17">
                        <c:v>17.100000000000001</c:v>
                      </c:pt>
                    </c:numCache>
                  </c:numRef>
                </c:yVal>
                <c:smooth val="1"/>
                <c:extLst>
                  <c:ext xmlns:c16="http://schemas.microsoft.com/office/drawing/2014/chart" uri="{C3380CC4-5D6E-409C-BE32-E72D297353CC}">
                    <c16:uniqueId val="{00000004-10B4-49A5-A90E-C973969B8D8B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E$37</c15:sqref>
                        </c15:formulaRef>
                      </c:ext>
                    </c:extLst>
                    <c:strCache>
                      <c:ptCount val="1"/>
                      <c:pt idx="0">
                        <c:v>HGF #15 R (F)</c:v>
                      </c:pt>
                    </c:strCache>
                  </c:strRef>
                </c:tx>
                <c:spPr>
                  <a:ln w="19050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A$38:$A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E$38:$E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225.26</c:v>
                      </c:pt>
                      <c:pt idx="1">
                        <c:v>207.83</c:v>
                      </c:pt>
                      <c:pt idx="2">
                        <c:v>178.54</c:v>
                      </c:pt>
                      <c:pt idx="3">
                        <c:v>156.82</c:v>
                      </c:pt>
                      <c:pt idx="4">
                        <c:v>114.38</c:v>
                      </c:pt>
                      <c:pt idx="5">
                        <c:v>69.63</c:v>
                      </c:pt>
                      <c:pt idx="6">
                        <c:v>45.86</c:v>
                      </c:pt>
                      <c:pt idx="7">
                        <c:v>32.86</c:v>
                      </c:pt>
                      <c:pt idx="8">
                        <c:v>28.79</c:v>
                      </c:pt>
                      <c:pt idx="9">
                        <c:v>26.01</c:v>
                      </c:pt>
                      <c:pt idx="10">
                        <c:v>24.5</c:v>
                      </c:pt>
                      <c:pt idx="11">
                        <c:v>23.41</c:v>
                      </c:pt>
                      <c:pt idx="12">
                        <c:v>22.87</c:v>
                      </c:pt>
                      <c:pt idx="13">
                        <c:v>22.32</c:v>
                      </c:pt>
                      <c:pt idx="14">
                        <c:v>22.32</c:v>
                      </c:pt>
                      <c:pt idx="15">
                        <c:v>25.73</c:v>
                      </c:pt>
                      <c:pt idx="16">
                        <c:v>31.77</c:v>
                      </c:pt>
                      <c:pt idx="17">
                        <c:v>39.68</c:v>
                      </c:pt>
                      <c:pt idx="18">
                        <c:v>41.45</c:v>
                      </c:pt>
                      <c:pt idx="19">
                        <c:v>42.33</c:v>
                      </c:pt>
                      <c:pt idx="20">
                        <c:v>45.3</c:v>
                      </c:pt>
                      <c:pt idx="21">
                        <c:v>46.23</c:v>
                      </c:pt>
                      <c:pt idx="22">
                        <c:v>47.15</c:v>
                      </c:pt>
                      <c:pt idx="23">
                        <c:v>53.66</c:v>
                      </c:pt>
                      <c:pt idx="24">
                        <c:v>68.930000000000007</c:v>
                      </c:pt>
                      <c:pt idx="25">
                        <c:v>81.93</c:v>
                      </c:pt>
                      <c:pt idx="26">
                        <c:v>89.89</c:v>
                      </c:pt>
                      <c:pt idx="27">
                        <c:v>104.36</c:v>
                      </c:pt>
                      <c:pt idx="28">
                        <c:v>109.33</c:v>
                      </c:pt>
                      <c:pt idx="29">
                        <c:v>133.12</c:v>
                      </c:pt>
                      <c:pt idx="30">
                        <c:v>168.34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10B4-49A5-A90E-C973969B8D8B}"/>
                  </c:ext>
                </c:extLst>
              </c15:ser>
            </c15:filteredScatterSeries>
            <c15:filteredScatte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F$3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19050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A$38:$A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F$38:$F$68</c15:sqref>
                        </c15:formulaRef>
                      </c:ext>
                    </c:extLst>
                    <c:numCache>
                      <c:formatCode>General</c:formatCode>
                      <c:ptCount val="31"/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10B4-49A5-A90E-C973969B8D8B}"/>
                  </c:ext>
                </c:extLst>
              </c15:ser>
            </c15:filteredScatterSeries>
            <c15:filteredScatterSeries>
              <c15:ser>
                <c:idx val="5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G$3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19050" cap="rnd">
                    <a:solidFill>
                      <a:schemeClr val="accent6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/>
                    </a:solidFill>
                    <a:ln w="9525">
                      <a:solidFill>
                        <a:schemeClr val="accent6"/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A$38:$A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G$38:$G$68</c15:sqref>
                        </c15:formulaRef>
                      </c:ext>
                    </c:extLst>
                    <c:numCache>
                      <c:formatCode>General</c:formatCode>
                      <c:ptCount val="31"/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10B4-49A5-A90E-C973969B8D8B}"/>
                  </c:ext>
                </c:extLst>
              </c15:ser>
            </c15:filteredScatterSeries>
            <c15:filteredScatter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I$37</c15:sqref>
                        </c15:formulaRef>
                      </c:ext>
                    </c:extLst>
                    <c:strCache>
                      <c:ptCount val="1"/>
                      <c:pt idx="0">
                        <c:v>HGF #31 R (F)</c:v>
                      </c:pt>
                    </c:strCache>
                  </c:strRef>
                </c:tx>
                <c:spPr>
                  <a:ln w="19050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A$38:$A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I$38:$I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163.37</c:v>
                      </c:pt>
                      <c:pt idx="1">
                        <c:v>146.97999999999999</c:v>
                      </c:pt>
                      <c:pt idx="2">
                        <c:v>135</c:v>
                      </c:pt>
                      <c:pt idx="3">
                        <c:v>111.33</c:v>
                      </c:pt>
                      <c:pt idx="4">
                        <c:v>102.06</c:v>
                      </c:pt>
                      <c:pt idx="5">
                        <c:v>80</c:v>
                      </c:pt>
                      <c:pt idx="6">
                        <c:v>64.510000000000005</c:v>
                      </c:pt>
                      <c:pt idx="7">
                        <c:v>43.22</c:v>
                      </c:pt>
                      <c:pt idx="8">
                        <c:v>38.4</c:v>
                      </c:pt>
                      <c:pt idx="9">
                        <c:v>38.4</c:v>
                      </c:pt>
                      <c:pt idx="10">
                        <c:v>38.4</c:v>
                      </c:pt>
                      <c:pt idx="11">
                        <c:v>38.4</c:v>
                      </c:pt>
                      <c:pt idx="12">
                        <c:v>38.4</c:v>
                      </c:pt>
                      <c:pt idx="13">
                        <c:v>38.4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9-10B4-49A5-A90E-C973969B8D8B}"/>
                  </c:ext>
                </c:extLst>
              </c15:ser>
            </c15:filteredScatterSeries>
            <c15:filteredScatterSeries>
              <c15:ser>
                <c:idx val="9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K$37</c15:sqref>
                        </c15:formulaRef>
                      </c:ext>
                    </c:extLst>
                    <c:strCache>
                      <c:ptCount val="1"/>
                      <c:pt idx="0">
                        <c:v>HGF #32 R (F)</c:v>
                      </c:pt>
                    </c:strCache>
                  </c:strRef>
                </c:tx>
                <c:spPr>
                  <a:ln w="19050" cap="rnd">
                    <a:solidFill>
                      <a:schemeClr val="accent4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>
                        <a:lumMod val="60000"/>
                      </a:schemeClr>
                    </a:solidFill>
                    <a:ln w="9525">
                      <a:solidFill>
                        <a:schemeClr val="accent4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A$38:$A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0</c:v>
                      </c:pt>
                      <c:pt idx="1">
                        <c:v>3</c:v>
                      </c:pt>
                      <c:pt idx="2">
                        <c:v>7</c:v>
                      </c:pt>
                      <c:pt idx="3">
                        <c:v>10</c:v>
                      </c:pt>
                      <c:pt idx="4">
                        <c:v>14</c:v>
                      </c:pt>
                      <c:pt idx="5">
                        <c:v>17</c:v>
                      </c:pt>
                      <c:pt idx="6">
                        <c:v>21</c:v>
                      </c:pt>
                      <c:pt idx="7">
                        <c:v>24</c:v>
                      </c:pt>
                      <c:pt idx="8">
                        <c:v>28</c:v>
                      </c:pt>
                      <c:pt idx="9">
                        <c:v>31</c:v>
                      </c:pt>
                      <c:pt idx="10">
                        <c:v>35</c:v>
                      </c:pt>
                      <c:pt idx="11">
                        <c:v>38</c:v>
                      </c:pt>
                      <c:pt idx="12">
                        <c:v>42</c:v>
                      </c:pt>
                      <c:pt idx="13">
                        <c:v>45</c:v>
                      </c:pt>
                      <c:pt idx="14">
                        <c:v>48</c:v>
                      </c:pt>
                      <c:pt idx="15">
                        <c:v>51</c:v>
                      </c:pt>
                      <c:pt idx="16">
                        <c:v>55</c:v>
                      </c:pt>
                      <c:pt idx="17">
                        <c:v>58</c:v>
                      </c:pt>
                      <c:pt idx="18">
                        <c:v>62</c:v>
                      </c:pt>
                      <c:pt idx="19">
                        <c:v>65</c:v>
                      </c:pt>
                      <c:pt idx="20">
                        <c:v>69</c:v>
                      </c:pt>
                      <c:pt idx="21">
                        <c:v>72</c:v>
                      </c:pt>
                      <c:pt idx="22">
                        <c:v>76</c:v>
                      </c:pt>
                      <c:pt idx="23">
                        <c:v>79</c:v>
                      </c:pt>
                      <c:pt idx="24">
                        <c:v>83</c:v>
                      </c:pt>
                      <c:pt idx="25">
                        <c:v>86</c:v>
                      </c:pt>
                      <c:pt idx="26">
                        <c:v>90</c:v>
                      </c:pt>
                      <c:pt idx="27">
                        <c:v>93</c:v>
                      </c:pt>
                      <c:pt idx="28">
                        <c:v>97</c:v>
                      </c:pt>
                      <c:pt idx="29">
                        <c:v>100</c:v>
                      </c:pt>
                      <c:pt idx="30">
                        <c:v>10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AZD+FcK'!$K$38:$K$68</c15:sqref>
                        </c15:formulaRef>
                      </c:ext>
                    </c:extLst>
                    <c:numCache>
                      <c:formatCode>General</c:formatCode>
                      <c:ptCount val="31"/>
                      <c:pt idx="0">
                        <c:v>173.23</c:v>
                      </c:pt>
                      <c:pt idx="1">
                        <c:v>151.55000000000001</c:v>
                      </c:pt>
                      <c:pt idx="2">
                        <c:v>132.1</c:v>
                      </c:pt>
                      <c:pt idx="3">
                        <c:v>111.39</c:v>
                      </c:pt>
                      <c:pt idx="4">
                        <c:v>98.78</c:v>
                      </c:pt>
                      <c:pt idx="5">
                        <c:v>77.06</c:v>
                      </c:pt>
                      <c:pt idx="6">
                        <c:v>64.510000000000005</c:v>
                      </c:pt>
                      <c:pt idx="7">
                        <c:v>49.37</c:v>
                      </c:pt>
                      <c:pt idx="8">
                        <c:v>57.13</c:v>
                      </c:pt>
                      <c:pt idx="9">
                        <c:v>57.13</c:v>
                      </c:pt>
                      <c:pt idx="10">
                        <c:v>57.13</c:v>
                      </c:pt>
                      <c:pt idx="11">
                        <c:v>57.13</c:v>
                      </c:pt>
                      <c:pt idx="12">
                        <c:v>57.13</c:v>
                      </c:pt>
                      <c:pt idx="13">
                        <c:v>58.54</c:v>
                      </c:pt>
                      <c:pt idx="14">
                        <c:v>62.11</c:v>
                      </c:pt>
                      <c:pt idx="15">
                        <c:v>67.5</c:v>
                      </c:pt>
                      <c:pt idx="16">
                        <c:v>70</c:v>
                      </c:pt>
                      <c:pt idx="17">
                        <c:v>72.5</c:v>
                      </c:pt>
                      <c:pt idx="18">
                        <c:v>83.82</c:v>
                      </c:pt>
                      <c:pt idx="19">
                        <c:v>90.4</c:v>
                      </c:pt>
                      <c:pt idx="20">
                        <c:v>106.62</c:v>
                      </c:pt>
                      <c:pt idx="21">
                        <c:v>122.79</c:v>
                      </c:pt>
                      <c:pt idx="22">
                        <c:v>146.07</c:v>
                      </c:pt>
                      <c:pt idx="23">
                        <c:v>154.79</c:v>
                      </c:pt>
                      <c:pt idx="24">
                        <c:v>187.27</c:v>
                      </c:pt>
                      <c:pt idx="25">
                        <c:v>210.7</c:v>
                      </c:pt>
                    </c:numCache>
                  </c:numRef>
                </c:yVal>
                <c:smooth val="1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10B4-49A5-A90E-C973969B8D8B}"/>
                  </c:ext>
                </c:extLst>
              </c15:ser>
            </c15:filteredScatterSeries>
          </c:ext>
        </c:extLst>
      </c:scatterChart>
      <c:valAx>
        <c:axId val="13957409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Days after first dosing </a:t>
                </a:r>
              </a:p>
            </c:rich>
          </c:tx>
          <c:layout>
            <c:manualLayout>
              <c:xMode val="edge"/>
              <c:yMode val="edge"/>
              <c:x val="0.32868004110508853"/>
              <c:y val="0.937883455564108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t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5733792"/>
        <c:crosses val="autoZero"/>
        <c:crossBetween val="midCat"/>
      </c:valAx>
      <c:valAx>
        <c:axId val="1395733792"/>
        <c:scaling>
          <c:orientation val="minMax"/>
          <c:max val="5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Tumor volume (mm3)</a:t>
                </a:r>
              </a:p>
            </c:rich>
          </c:tx>
          <c:layout>
            <c:manualLayout>
              <c:xMode val="edge"/>
              <c:yMode val="edge"/>
              <c:x val="0"/>
              <c:y val="0.264784380280480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57409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rgbClr val="00B050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5993433-F7F2-4C6C-8CEA-571C028B7E3B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D60B8724-17CE-415A-8CAA-E4306F3CD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406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0B8724-17CE-415A-8CAA-E4306F3CDB4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9134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B5F023-6B9D-4F6C-84DE-D209D78DC6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BD839C-0DDB-41BF-856C-C3B39C102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0D240-2D15-407D-9E15-D21E4438BA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32F568-E783-4EAF-BF69-E8D77ADF4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B7D21-2A4D-432A-A25C-7A822AA2C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296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0D481-E82C-4763-A46B-3CAC3AC1B5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FAF905-8D17-40EE-9F0F-031C8DCC5D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24E867-0298-40B3-8506-24DD95ACB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8460B8-2B95-408D-98B1-5B1AE6B1B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BDCA23-C798-481E-A10C-08733F1497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74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EDEFD7-A864-4DBB-B0F4-45871EF21F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88068F-8E71-4C71-ABA1-4D44FD0E47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4F23A2-42B5-44F9-8475-5106DADBE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600386-4D46-41B4-845D-ACDE5A0EA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C2386E-4D9E-4F33-8826-E419D59B1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526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AEE98-CF26-4465-850E-F1468D868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BB96BD-E67F-48E4-BF7A-CD830E622A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F6D25E-A975-4654-9B05-7C635AA1B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ACE4A7-40ED-4E19-AA8D-481AE0D8C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39984-F76D-4FB2-AE5E-03B80A029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536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C422F2-D875-4B0E-8FE9-2F3FFD08F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56EA26-C358-4F8B-9975-AC6AED2FF9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7D4841-4046-4643-9ACC-C54B17B05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A98FF3-F7F1-4EC1-BC0A-41F74C7E7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D808D9-BB84-4EA7-BDA2-864E35EB28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895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0076C4-22E0-4326-A84F-D1D94E521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630061-62B3-4285-A107-13BE6C6745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102929-66DC-4936-B62A-E027328575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76273D-EB60-43B9-91D3-9F8602522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54C809-1DD0-4A7A-B024-55D0E50859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F1B794-38F4-4A44-B657-411FC98B0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811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7D37-0579-4906-8C69-D7F4A0D13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869939-8B7C-45FD-9101-3DF4E95B0E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057093-4CF6-4645-B8E6-B0A742C1A0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68530E-F8FA-40FD-B993-E47FC5BEE6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F31B76-DB99-475F-8E0B-7CA688F3F1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F7DC2F-BE93-4D60-9DDB-0A19F87B9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1C0F25-7CF3-4DEC-B8BA-0C36CDCB4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5915DC-B1EF-4AE7-A22F-3426E493A2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624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454793-0F06-4037-A3CA-352986DB34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47ED1E-806A-4EAF-A516-A855D82E0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FD2192-E901-42AB-B838-7AA63F9B8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9402FB-D8E6-4055-A522-7148BDE59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601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2082F4-B039-4C82-A260-3BB96124C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31740F7-C780-47B4-9BAE-6238B0959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B10FCD-0DC5-4700-A4DB-E0FD8D96A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583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DF4661-E58C-47AE-8587-27776C730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5D816B-9EFE-47D0-A3EE-4B78A3B4DD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29021E-9C83-4590-9BE7-02E69DD0A2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864328-7043-4B09-B23B-87CAD8315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3835B9-27B5-4CE7-BC6B-F68044392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C0F6CE-1567-4130-9323-4FDE36849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91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9CF22-9B34-49BF-B2F2-FE5A6D2C6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612AF4-E2A2-4384-B562-D16DAD9F14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003EC2-7C65-4DDB-BB21-16E47ED4CF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2C2E39-77CA-478E-AA71-EFB519CF7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D8EB90-5E72-4DC3-893A-11846CCCB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A50EAD-5388-4442-9400-90DC008E9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271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ACE4FFB-3949-4451-B74A-627781FF1C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D43352-3BF3-436B-B670-61850936F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5287E0-7289-4F02-8FE8-3A03478BFB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B5986F-AD0D-48E4-A265-5F9327DC8D59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3035EB-C6F1-4E0D-83A4-D41B26357A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D3A7A1-2762-4F2C-B324-AE6AAD2DBD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6CDB7-5727-4AF5-B558-0255E7A610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930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972E5C4F-4DBA-4D2B-4D9B-40C3D1E0FB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6032326"/>
              </p:ext>
            </p:extLst>
          </p:nvPr>
        </p:nvGraphicFramePr>
        <p:xfrm>
          <a:off x="6193682" y="1056790"/>
          <a:ext cx="2813277" cy="30999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FBD034F2-3EF7-82F9-B597-0CFC2DA101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7262638"/>
              </p:ext>
            </p:extLst>
          </p:nvPr>
        </p:nvGraphicFramePr>
        <p:xfrm>
          <a:off x="3083655" y="1048038"/>
          <a:ext cx="2813277" cy="31087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AD3AA5F-2EF9-785E-6D95-7574A3D15251}"/>
              </a:ext>
            </a:extLst>
          </p:cNvPr>
          <p:cNvSpPr txBox="1"/>
          <p:nvPr/>
        </p:nvSpPr>
        <p:spPr>
          <a:xfrm>
            <a:off x="6710535" y="1118349"/>
            <a:ext cx="1547446" cy="206210"/>
          </a:xfrm>
          <a:prstGeom prst="homePlate">
            <a:avLst/>
          </a:prstGeom>
          <a:ln>
            <a:noFill/>
          </a:ln>
        </p:spPr>
        <p:style>
          <a:lnRef idx="3">
            <a:schemeClr val="lt1"/>
          </a:lnRef>
          <a:fillRef idx="1">
            <a:schemeClr val="accent4"/>
          </a:fillRef>
          <a:effectRef idx="1">
            <a:schemeClr val="accent4"/>
          </a:effectRef>
          <a:fontRef idx="minor">
            <a:schemeClr val="lt1"/>
          </a:fontRef>
        </p:style>
        <p:txBody>
          <a:bodyPr wrap="square" lIns="192024" tIns="18288" rIns="192024" bIns="18288" rtlCol="0" anchor="ctr">
            <a:spAutoFit/>
          </a:bodyPr>
          <a:lstStyle/>
          <a:p>
            <a:pPr algn="ctr"/>
            <a:r>
              <a:rPr lang="en-US" sz="1100" b="1" dirty="0" err="1">
                <a:solidFill>
                  <a:schemeClr val="bg1"/>
                </a:solidFill>
              </a:rPr>
              <a:t>Osi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809460-5F8D-DB82-2248-FC0BF4B2D1D8}"/>
              </a:ext>
            </a:extLst>
          </p:cNvPr>
          <p:cNvSpPr txBox="1"/>
          <p:nvPr/>
        </p:nvSpPr>
        <p:spPr>
          <a:xfrm>
            <a:off x="3579433" y="1052653"/>
            <a:ext cx="1433356" cy="187744"/>
          </a:xfrm>
          <a:prstGeom prst="homePlate">
            <a:avLst/>
          </a:prstGeom>
          <a:ln>
            <a:noFill/>
          </a:ln>
        </p:spPr>
        <p:style>
          <a:lnRef idx="3">
            <a:schemeClr val="lt1"/>
          </a:lnRef>
          <a:fillRef idx="1">
            <a:schemeClr val="accent4"/>
          </a:fillRef>
          <a:effectRef idx="1">
            <a:schemeClr val="accent4"/>
          </a:effectRef>
          <a:fontRef idx="minor">
            <a:schemeClr val="lt1"/>
          </a:fontRef>
        </p:style>
        <p:txBody>
          <a:bodyPr wrap="square" lIns="18288" tIns="9144" rIns="18288" bIns="9144" rtlCol="0" anchor="ctr">
            <a:spAutoFit/>
          </a:bodyPr>
          <a:lstStyle/>
          <a:p>
            <a:pPr algn="ctr"/>
            <a:r>
              <a:rPr lang="en-US" sz="1100" b="1" dirty="0" err="1">
                <a:solidFill>
                  <a:schemeClr val="bg1"/>
                </a:solidFill>
              </a:rPr>
              <a:t>Osi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F02F515-B200-546C-7D36-4B2D9B33B043}"/>
              </a:ext>
            </a:extLst>
          </p:cNvPr>
          <p:cNvSpPr txBox="1"/>
          <p:nvPr/>
        </p:nvSpPr>
        <p:spPr>
          <a:xfrm>
            <a:off x="4117803" y="1243103"/>
            <a:ext cx="891372" cy="187744"/>
          </a:xfrm>
          <a:prstGeom prst="homePlate">
            <a:avLst/>
          </a:prstGeom>
          <a:ln>
            <a:noFill/>
          </a:ln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wrap="square" lIns="18288" tIns="9144" rIns="18288" bIns="9144" rtlCol="0" anchor="ctr">
            <a:spAutoFit/>
          </a:bodyPr>
          <a:lstStyle/>
          <a:p>
            <a:pPr algn="ctr"/>
            <a:r>
              <a:rPr lang="en-US" sz="1100" b="1" dirty="0">
                <a:solidFill>
                  <a:schemeClr val="bg1"/>
                </a:solidFill>
              </a:rPr>
              <a:t>H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809BC75-1313-C616-3D26-24B771146338}"/>
              </a:ext>
            </a:extLst>
          </p:cNvPr>
          <p:cNvSpPr txBox="1"/>
          <p:nvPr/>
        </p:nvSpPr>
        <p:spPr>
          <a:xfrm>
            <a:off x="6193682" y="1057189"/>
            <a:ext cx="181140" cy="215444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lIns="0" tIns="0" rIns="0" bIns="0" rtlCol="0">
            <a:spAutoFit/>
          </a:bodyPr>
          <a:lstStyle/>
          <a:p>
            <a:r>
              <a:rPr lang="en-US" sz="1400" b="1" dirty="0"/>
              <a:t> B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72A4881-FCEC-152B-9B81-2CC002DCEEA2}"/>
              </a:ext>
            </a:extLst>
          </p:cNvPr>
          <p:cNvSpPr txBox="1"/>
          <p:nvPr/>
        </p:nvSpPr>
        <p:spPr>
          <a:xfrm>
            <a:off x="3093529" y="1056790"/>
            <a:ext cx="189154" cy="215444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lIns="0" tIns="0" rIns="0" bIns="0" rtlCol="0">
            <a:spAutoFit/>
          </a:bodyPr>
          <a:lstStyle/>
          <a:p>
            <a:r>
              <a:rPr lang="en-US" sz="1400" b="1" dirty="0"/>
              <a:t> A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F565B13-C1CD-0C32-B768-079C60AADBB7}"/>
              </a:ext>
            </a:extLst>
          </p:cNvPr>
          <p:cNvSpPr txBox="1"/>
          <p:nvPr/>
        </p:nvSpPr>
        <p:spPr>
          <a:xfrm>
            <a:off x="961574" y="4505400"/>
            <a:ext cx="10826496" cy="18578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 Figure 3. Effect of anti-HDGF antibody </a:t>
            </a:r>
            <a:r>
              <a:rPr lang="en-US" sz="1800" b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3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on post-progression tumor</a:t>
            </a:r>
            <a:endParaRPr lang="en-US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 bearing established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M00219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DX tumor (300 to 350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m</a:t>
            </a:r>
            <a:r>
              <a:rPr lang="en-US" sz="1800" kern="100" baseline="300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, n = 4) were treated with osimertinib (10 mg/kg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.o.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. After progression, anti-HDGF antibody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3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(13 mg/kg,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.p.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8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.i.w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) was added to the treatment regimen in combination with osimertinib. Arrow indicate approximate time of antibody administration. Tumor volumes were measured twice a week and plotted as shown in 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The effect of osimertinib monotherapy was shown in 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s comparison (reproduced from Figure 2). </a:t>
            </a:r>
            <a:endParaRPr lang="en-US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0991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16</TotalTime>
  <Words>139</Words>
  <Application>Microsoft Office PowerPoint</Application>
  <PresentationFormat>Widescreen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n, Hening</dc:creator>
  <cp:lastModifiedBy>Ren, Hening</cp:lastModifiedBy>
  <cp:revision>27</cp:revision>
  <cp:lastPrinted>2024-01-09T16:49:54Z</cp:lastPrinted>
  <dcterms:created xsi:type="dcterms:W3CDTF">2022-08-03T20:55:56Z</dcterms:created>
  <dcterms:modified xsi:type="dcterms:W3CDTF">2024-07-10T16:40:18Z</dcterms:modified>
</cp:coreProperties>
</file>